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4.xml" ContentType="application/vnd.openxmlformats-officedocument.presentationml.slide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16.xml.rels" ContentType="application/vnd.openxmlformats-package.relationships+xml"/>
  <Override PartName="/ppt/slides/_rels/slide32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21.xml.rels" ContentType="application/vnd.openxmlformats-package.relationships+xml"/>
  <Override PartName="/ppt/slides/_rels/slide8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7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7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8.xml.rels" ContentType="application/vnd.openxmlformats-package.relationships+xml"/>
  <Override PartName="/ppt/slides/_rels/slide22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slide30.xml" ContentType="application/vnd.openxmlformats-officedocument.presentationml.slide+xml"/>
  <Override PartName="/ppt/slides/slide5.xml" ContentType="application/vnd.openxmlformats-officedocument.presentationml.slide+xml"/>
  <Override PartName="/ppt/slides/slide31.xml" ContentType="application/vnd.openxmlformats-officedocument.presentationml.slide+xml"/>
  <Override PartName="/ppt/slides/slide6.xml" ContentType="application/vnd.openxmlformats-officedocument.presentationml.slide+xml"/>
  <Override PartName="/ppt/slides/slide32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</p:sldIdLst>
  <p:sldSz cx="9144000" cy="6858000"/>
  <p:notesSz cx="6858000" cy="9144000"/>
  <p:custShowLst>
    <p:custShow name="Syringe-Animation-1" id="0">
      <p:sldLst>
        <p:sld r:id="rId4"/>
        <p:sld r:id="rId5"/>
        <p:sld r:id="rId6"/>
        <p:sld r:id="rId7"/>
        <p:sld r:id="rId8"/>
        <p:sld r:id="rId9"/>
        <p:sld r:id="rId10"/>
        <p:sld r:id="rId11"/>
        <p:sld r:id="rId12"/>
        <p:sld r:id="rId13"/>
        <p:sld r:id="rId14"/>
        <p:sld r:id="rId15"/>
        <p:sld r:id="rId16"/>
        <p:sld r:id="rId17"/>
        <p:sld r:id="rId18"/>
        <p:sld r:id="rId19"/>
        <p:sld r:id="rId20"/>
        <p:sld r:id="rId21"/>
        <p:sld r:id="rId22"/>
        <p:sld r:id="rId23"/>
        <p:sld r:id="rId24"/>
        <p:sld r:id="rId25"/>
        <p:sld r:id="rId26"/>
        <p:sld r:id="rId27"/>
        <p:sld r:id="rId28"/>
        <p:sld r:id="rId29"/>
        <p:sld r:id="rId30"/>
        <p:sld r:id="rId31"/>
        <p:sld r:id="rId32"/>
        <p:sld r:id="rId33"/>
        <p:sld r:id="rId34"/>
      </p:sldLst>
    </p:custShow>
    <p:custShow name="Main" id="1">
      <p:sldLst>
        <p:sld r:id="rId3"/>
      </p:sldLst>
    </p:custShow>
  </p:custShow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custShow id="1"/>
  </p:showPr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45177-8A1E-46BA-977B-9C27B588AB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27198-3911-4190-ADE0-5F1F7CA88A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EEDEA-C75F-4FAD-A5A0-9DD045C38E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86DA8-54AA-45D8-9E0A-48BEE12020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8707F-1304-46B6-B8D4-62B10E9204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2A7A0-D0D4-4C25-BCD4-8DEAABCBAF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AFBD3-3BC2-47BD-97ED-65F0E148D2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017EA-6B04-421A-8CDF-2BA4D79899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AE446-7450-45C0-9AE9-6256FA7FCD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F39F2-1715-4BCD-996C-B25DE42E61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96EBA-9535-485A-9F47-76F3D1D2FB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6C25D-17F0-4E49-91C5-E01686075C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98A3F7-6FCA-42BD-B8A1-79843353800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162920" y="5191200"/>
            <a:ext cx="419040" cy="352440"/>
          </a:xfrm>
          <a:custGeom>
            <a:avLst/>
            <a:gdLst>
              <a:gd name="textAreaLeft" fmla="*/ 22680 w 419040"/>
              <a:gd name="textAreaRight" fmla="*/ 396360 w 419040"/>
              <a:gd name="textAreaTop" fmla="*/ 22680 h 352440"/>
              <a:gd name="textAreaBottom" fmla="*/ 329760 h 352440"/>
            </a:gdLst>
            <a:ahLst/>
            <a:rect l="textAreaLeft" t="textAreaTop" r="textAreaRight" b="textAreaBottom"/>
            <a:pathLst>
              <a:path w="25678" h="21600">
                <a:moveTo>
                  <a:pt x="0" y="0"/>
                </a:moveTo>
                <a:lnTo>
                  <a:pt x="25678" y="0"/>
                </a:lnTo>
                <a:lnTo>
                  <a:pt x="25678" y="21600"/>
                </a:lnTo>
                <a:lnTo>
                  <a:pt x="0" y="21600"/>
                </a:lnTo>
                <a:close/>
              </a:path>
              <a:path fill="lightenLess" w="25678" h="21600">
                <a:moveTo>
                  <a:pt x="0" y="0"/>
                </a:moveTo>
                <a:lnTo>
                  <a:pt x="25678" y="0"/>
                </a:lnTo>
                <a:lnTo>
                  <a:pt x="24278" y="1400"/>
                </a:lnTo>
                <a:lnTo>
                  <a:pt x="1400" y="1400"/>
                </a:lnTo>
                <a:close/>
              </a:path>
              <a:path fill="darken" w="25678" h="21600">
                <a:moveTo>
                  <a:pt x="25678" y="0"/>
                </a:moveTo>
                <a:lnTo>
                  <a:pt x="25678" y="21600"/>
                </a:lnTo>
                <a:lnTo>
                  <a:pt x="24278" y="20200"/>
                </a:lnTo>
                <a:lnTo>
                  <a:pt x="24278" y="1400"/>
                </a:lnTo>
                <a:close/>
              </a:path>
              <a:path fill="darkenLess" w="25678" h="21600">
                <a:moveTo>
                  <a:pt x="25678" y="21600"/>
                </a:moveTo>
                <a:lnTo>
                  <a:pt x="0" y="21600"/>
                </a:lnTo>
                <a:lnTo>
                  <a:pt x="1400" y="20200"/>
                </a:lnTo>
                <a:lnTo>
                  <a:pt x="24278" y="20200"/>
                </a:lnTo>
                <a:close/>
              </a:path>
              <a:path fill="lighten" w="25678" h="21600">
                <a:moveTo>
                  <a:pt x="0" y="21600"/>
                </a:moveTo>
                <a:lnTo>
                  <a:pt x="0" y="0"/>
                </a:lnTo>
                <a:lnTo>
                  <a:pt x="1400" y="1400"/>
                </a:lnTo>
                <a:lnTo>
                  <a:pt x="1400" y="20200"/>
                </a:lnTo>
                <a:close/>
              </a:path>
              <a:path fill="darken" w="25678" h="21600">
                <a:moveTo>
                  <a:pt x="5832" y="3794"/>
                </a:moveTo>
                <a:lnTo>
                  <a:pt x="19845" y="10800"/>
                </a:lnTo>
                <a:lnTo>
                  <a:pt x="5832" y="17806"/>
                </a:lnTo>
                <a:close/>
              </a:path>
            </a:pathLst>
          </a:cu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flipH="1">
            <a:off x="4764960" y="4143240"/>
            <a:ext cx="2592360" cy="854280"/>
          </a:xfrm>
          <a:prstGeom prst="wedgeRoundRectCallout">
            <a:avLst>
              <a:gd name="adj1" fmla="val -43754"/>
              <a:gd name="adj2" fmla="val 79921"/>
              <a:gd name="adj3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66ff"/>
                </a:solidFill>
                <a:latin typeface="Arial"/>
              </a:rPr>
              <a:t>Click on this icon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66ff"/>
                </a:solidFill>
                <a:latin typeface="Arial"/>
              </a:rPr>
              <a:t>to start animation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831200" y="5910120"/>
            <a:ext cx="3882600" cy="64260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At the end of animation</a:t>
            </a: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,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‘</a:t>
            </a: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right click’ and select ‘end show’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80160" y="5921280"/>
            <a:ext cx="3944880" cy="642600"/>
          </a:xfrm>
          <a:prstGeom prst="rect">
            <a:avLst/>
          </a:prstGeom>
          <a:solidFill>
            <a:srgbClr val="0066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To hasten the speed of animation,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You may ‘left click’ continuously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75" name=""/>
          <p:cNvSpPr/>
          <p:nvPr/>
        </p:nvSpPr>
        <p:spPr>
          <a:xfrm flipV="1">
            <a:off x="2470320" y="3962160"/>
            <a:ext cx="1292040" cy="8650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2813040" y="3962160"/>
            <a:ext cx="942840" cy="63180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3360000">
            <a:off x="3097800" y="409464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rot="3480000">
            <a:off x="3549600" y="39891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0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81" name=""/>
          <p:cNvSpPr/>
          <p:nvPr/>
        </p:nvSpPr>
        <p:spPr>
          <a:xfrm flipV="1">
            <a:off x="2317680" y="3919680"/>
            <a:ext cx="1508040" cy="10094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2855880" y="3933360"/>
            <a:ext cx="942840" cy="63180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3360000">
            <a:off x="3140640" y="406584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3480000">
            <a:off x="3592440" y="3960720"/>
            <a:ext cx="4572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rot="3480000">
            <a:off x="2506680" y="4689360"/>
            <a:ext cx="4572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1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88" name=""/>
          <p:cNvSpPr/>
          <p:nvPr/>
        </p:nvSpPr>
        <p:spPr>
          <a:xfrm flipV="1">
            <a:off x="1457280" y="4787640"/>
            <a:ext cx="1233360" cy="8506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rot="3360000">
            <a:off x="1912320" y="5004720"/>
            <a:ext cx="42840" cy="5997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3420000">
            <a:off x="2363400" y="48992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2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 advTm="1000">
    <p:fade/>
  </p:transition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 flipV="1">
            <a:off x="1457280" y="4609800"/>
            <a:ext cx="1506600" cy="101916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3360000">
            <a:off x="2225880" y="4794840"/>
            <a:ext cx="4320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rot="3480000">
            <a:off x="2678040" y="4689360"/>
            <a:ext cx="4572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3480000">
            <a:off x="1592280" y="54180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3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99" name=""/>
          <p:cNvSpPr/>
          <p:nvPr/>
        </p:nvSpPr>
        <p:spPr>
          <a:xfrm flipV="1">
            <a:off x="1438200" y="4381560"/>
            <a:ext cx="1868400" cy="12571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rot="3360000">
            <a:off x="2468880" y="462312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3480000">
            <a:off x="2921040" y="45176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3480000">
            <a:off x="1834560" y="52462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4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105" name=""/>
          <p:cNvSpPr/>
          <p:nvPr/>
        </p:nvSpPr>
        <p:spPr>
          <a:xfrm flipV="1">
            <a:off x="1438200" y="3848040"/>
            <a:ext cx="2660760" cy="17906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rot="3480000">
            <a:off x="3534840" y="41032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rot="3360000">
            <a:off x="2598120" y="4537800"/>
            <a:ext cx="42840" cy="5997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rot="3480000">
            <a:off x="3049560" y="44319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rot="3480000">
            <a:off x="1963800" y="51606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5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112" name=""/>
          <p:cNvSpPr/>
          <p:nvPr/>
        </p:nvSpPr>
        <p:spPr>
          <a:xfrm flipV="1">
            <a:off x="1438200" y="3848040"/>
            <a:ext cx="2660760" cy="17906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rot="3360000">
            <a:off x="2526120" y="458028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rot="960000">
            <a:off x="4314600" y="34592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rot="3480000">
            <a:off x="3534840" y="41032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rot="3480000">
            <a:off x="1849320" y="524628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6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120" name=""/>
          <p:cNvSpPr/>
          <p:nvPr/>
        </p:nvSpPr>
        <p:spPr>
          <a:xfrm flipV="1">
            <a:off x="1438200" y="3848040"/>
            <a:ext cx="2660760" cy="17906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rot="3360000">
            <a:off x="3711600" y="39938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rot="3360000">
            <a:off x="2997720" y="426600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rot="960000">
            <a:off x="4428720" y="315900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rot="3480000">
            <a:off x="1906560" y="52034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7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133" name=""/>
          <p:cNvSpPr/>
          <p:nvPr/>
        </p:nvSpPr>
        <p:spPr>
          <a:xfrm flipV="1">
            <a:off x="1438200" y="3848040"/>
            <a:ext cx="2660760" cy="17906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981680" y="2270160"/>
            <a:ext cx="799920" cy="3776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981680" y="2270160"/>
            <a:ext cx="799920" cy="3776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3360000">
            <a:off x="3711600" y="39938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3360000">
            <a:off x="1868760" y="5023440"/>
            <a:ext cx="43200" cy="5997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3177000">
            <a:off x="4677840" y="276084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rot="960000">
            <a:off x="4428720" y="315900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3480000">
            <a:off x="2778120" y="461772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rot="3451200">
            <a:off x="5376960" y="226116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8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148" name=""/>
          <p:cNvSpPr/>
          <p:nvPr/>
        </p:nvSpPr>
        <p:spPr>
          <a:xfrm flipV="1">
            <a:off x="1438200" y="3848040"/>
            <a:ext cx="2660760" cy="17906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981680" y="2270160"/>
            <a:ext cx="799920" cy="3776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5715000" y="2305080"/>
            <a:ext cx="130320" cy="266760"/>
          </a:xfrm>
          <a:custGeom>
            <a:avLst/>
            <a:gdLst/>
            <a:ahLst/>
            <a:rect l="l" t="t" r="r" b="b"/>
            <a:pathLst>
              <a:path w="82" h="168">
                <a:moveTo>
                  <a:pt x="42" y="0"/>
                </a:moveTo>
                <a:cubicBezTo>
                  <a:pt x="27" y="23"/>
                  <a:pt x="20" y="47"/>
                  <a:pt x="12" y="72"/>
                </a:cubicBezTo>
                <a:cubicBezTo>
                  <a:pt x="8" y="84"/>
                  <a:pt x="0" y="108"/>
                  <a:pt x="0" y="108"/>
                </a:cubicBezTo>
                <a:cubicBezTo>
                  <a:pt x="9" y="143"/>
                  <a:pt x="12" y="156"/>
                  <a:pt x="48" y="168"/>
                </a:cubicBezTo>
                <a:cubicBezTo>
                  <a:pt x="82" y="157"/>
                  <a:pt x="68" y="138"/>
                  <a:pt x="78" y="108"/>
                </a:cubicBezTo>
                <a:cubicBezTo>
                  <a:pt x="74" y="92"/>
                  <a:pt x="62" y="26"/>
                  <a:pt x="54" y="18"/>
                </a:cubicBezTo>
                <a:cubicBezTo>
                  <a:pt x="50" y="14"/>
                  <a:pt x="40" y="17"/>
                  <a:pt x="36" y="12"/>
                </a:cubicBezTo>
                <a:cubicBezTo>
                  <a:pt x="34" y="8"/>
                  <a:pt x="40" y="4"/>
                  <a:pt x="42" y="0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5754600" y="233676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rot="3360000">
            <a:off x="2311920" y="472320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rot="3177000">
            <a:off x="4677840" y="276084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rot="960000">
            <a:off x="4428720" y="315900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rot="3480000">
            <a:off x="3463920" y="416052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rot="3451200">
            <a:off x="5376960" y="226116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19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161" name=""/>
          <p:cNvSpPr/>
          <p:nvPr/>
        </p:nvSpPr>
        <p:spPr>
          <a:xfrm flipV="1">
            <a:off x="1438200" y="3848040"/>
            <a:ext cx="2660760" cy="17906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981680" y="2270160"/>
            <a:ext cx="799920" cy="3776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5676840" y="2266920"/>
            <a:ext cx="196920" cy="638280"/>
          </a:xfrm>
          <a:custGeom>
            <a:avLst/>
            <a:gdLst/>
            <a:ahLst/>
            <a:rect l="l" t="t" r="r" b="b"/>
            <a:pathLst>
              <a:path w="82" h="168">
                <a:moveTo>
                  <a:pt x="42" y="0"/>
                </a:moveTo>
                <a:cubicBezTo>
                  <a:pt x="27" y="23"/>
                  <a:pt x="20" y="47"/>
                  <a:pt x="12" y="72"/>
                </a:cubicBezTo>
                <a:cubicBezTo>
                  <a:pt x="8" y="84"/>
                  <a:pt x="0" y="108"/>
                  <a:pt x="0" y="108"/>
                </a:cubicBezTo>
                <a:cubicBezTo>
                  <a:pt x="9" y="143"/>
                  <a:pt x="12" y="156"/>
                  <a:pt x="48" y="168"/>
                </a:cubicBezTo>
                <a:cubicBezTo>
                  <a:pt x="82" y="157"/>
                  <a:pt x="68" y="138"/>
                  <a:pt x="78" y="108"/>
                </a:cubicBezTo>
                <a:cubicBezTo>
                  <a:pt x="74" y="92"/>
                  <a:pt x="62" y="26"/>
                  <a:pt x="54" y="18"/>
                </a:cubicBezTo>
                <a:cubicBezTo>
                  <a:pt x="50" y="14"/>
                  <a:pt x="40" y="17"/>
                  <a:pt x="36" y="12"/>
                </a:cubicBezTo>
                <a:cubicBezTo>
                  <a:pt x="34" y="8"/>
                  <a:pt x="40" y="4"/>
                  <a:pt x="42" y="0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5718240" y="2643120"/>
            <a:ext cx="4608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rot="19968000">
            <a:off x="5781600" y="237312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rot="1428600">
            <a:off x="5772240" y="26730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rot="19675200">
            <a:off x="5764320" y="24746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981680" y="2270160"/>
            <a:ext cx="799920" cy="3776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5715000" y="2305080"/>
            <a:ext cx="130320" cy="266760"/>
          </a:xfrm>
          <a:custGeom>
            <a:avLst/>
            <a:gdLst/>
            <a:ahLst/>
            <a:rect l="l" t="t" r="r" b="b"/>
            <a:pathLst>
              <a:path w="82" h="168">
                <a:moveTo>
                  <a:pt x="42" y="0"/>
                </a:moveTo>
                <a:cubicBezTo>
                  <a:pt x="27" y="23"/>
                  <a:pt x="20" y="47"/>
                  <a:pt x="12" y="72"/>
                </a:cubicBezTo>
                <a:cubicBezTo>
                  <a:pt x="8" y="84"/>
                  <a:pt x="0" y="108"/>
                  <a:pt x="0" y="108"/>
                </a:cubicBezTo>
                <a:cubicBezTo>
                  <a:pt x="9" y="143"/>
                  <a:pt x="12" y="156"/>
                  <a:pt x="48" y="168"/>
                </a:cubicBezTo>
                <a:cubicBezTo>
                  <a:pt x="82" y="157"/>
                  <a:pt x="68" y="138"/>
                  <a:pt x="78" y="108"/>
                </a:cubicBezTo>
                <a:cubicBezTo>
                  <a:pt x="74" y="92"/>
                  <a:pt x="62" y="26"/>
                  <a:pt x="54" y="18"/>
                </a:cubicBezTo>
                <a:cubicBezTo>
                  <a:pt x="50" y="14"/>
                  <a:pt x="40" y="17"/>
                  <a:pt x="36" y="12"/>
                </a:cubicBezTo>
                <a:cubicBezTo>
                  <a:pt x="34" y="8"/>
                  <a:pt x="40" y="4"/>
                  <a:pt x="42" y="0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5754600" y="233676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rot="3360000">
            <a:off x="2968920" y="428040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rot="3177000">
            <a:off x="4677840" y="276084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rot="3480000">
            <a:off x="4077720" y="3732120"/>
            <a:ext cx="4572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rot="3451200">
            <a:off x="5376960" y="226116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0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181" name=""/>
          <p:cNvSpPr/>
          <p:nvPr/>
        </p:nvSpPr>
        <p:spPr>
          <a:xfrm flipV="1">
            <a:off x="1438200" y="3848040"/>
            <a:ext cx="2660760" cy="179064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981680" y="2270160"/>
            <a:ext cx="799920" cy="3776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5662440" y="2324160"/>
            <a:ext cx="411480" cy="914400"/>
          </a:xfrm>
          <a:custGeom>
            <a:avLst/>
            <a:gdLst/>
            <a:ahLst/>
            <a:rect l="l" t="t" r="r" b="b"/>
            <a:pathLst>
              <a:path w="259" h="576">
                <a:moveTo>
                  <a:pt x="57" y="96"/>
                </a:moveTo>
                <a:cubicBezTo>
                  <a:pt x="50" y="177"/>
                  <a:pt x="35" y="264"/>
                  <a:pt x="9" y="342"/>
                </a:cubicBezTo>
                <a:cubicBezTo>
                  <a:pt x="0" y="413"/>
                  <a:pt x="11" y="480"/>
                  <a:pt x="51" y="540"/>
                </a:cubicBezTo>
                <a:cubicBezTo>
                  <a:pt x="54" y="544"/>
                  <a:pt x="123" y="570"/>
                  <a:pt x="123" y="570"/>
                </a:cubicBezTo>
                <a:cubicBezTo>
                  <a:pt x="129" y="572"/>
                  <a:pt x="141" y="576"/>
                  <a:pt x="141" y="576"/>
                </a:cubicBezTo>
                <a:cubicBezTo>
                  <a:pt x="177" y="571"/>
                  <a:pt x="207" y="566"/>
                  <a:pt x="237" y="546"/>
                </a:cubicBezTo>
                <a:cubicBezTo>
                  <a:pt x="241" y="533"/>
                  <a:pt x="254" y="523"/>
                  <a:pt x="255" y="510"/>
                </a:cubicBezTo>
                <a:cubicBezTo>
                  <a:pt x="259" y="465"/>
                  <a:pt x="230" y="400"/>
                  <a:pt x="219" y="354"/>
                </a:cubicBezTo>
                <a:cubicBezTo>
                  <a:pt x="218" y="327"/>
                  <a:pt x="222" y="243"/>
                  <a:pt x="201" y="204"/>
                </a:cubicBezTo>
                <a:cubicBezTo>
                  <a:pt x="177" y="161"/>
                  <a:pt x="143" y="123"/>
                  <a:pt x="123" y="78"/>
                </a:cubicBezTo>
                <a:cubicBezTo>
                  <a:pt x="109" y="45"/>
                  <a:pt x="107" y="13"/>
                  <a:pt x="69" y="0"/>
                </a:cubicBezTo>
                <a:cubicBezTo>
                  <a:pt x="65" y="12"/>
                  <a:pt x="61" y="24"/>
                  <a:pt x="57" y="36"/>
                </a:cubicBezTo>
                <a:cubicBezTo>
                  <a:pt x="51" y="55"/>
                  <a:pt x="63" y="77"/>
                  <a:pt x="57" y="96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5883120" y="25797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803920" y="2585880"/>
            <a:ext cx="46080" cy="136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rot="3177000">
            <a:off x="5949720" y="3045960"/>
            <a:ext cx="4572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 rot="19968000">
            <a:off x="5781600" y="234432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rot="1428600">
            <a:off x="5785920" y="293004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rot="19675200">
            <a:off x="5921280" y="286020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rot="1862400">
            <a:off x="5748120" y="2733840"/>
            <a:ext cx="4572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095720" y="3209760"/>
            <a:ext cx="362160" cy="63828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4457880" y="2638440"/>
            <a:ext cx="542880" cy="57132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rot="3360000">
            <a:off x="3726360" y="378036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rot="3300000">
            <a:off x="5063760" y="24746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1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0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201" name=""/>
          <p:cNvSpPr/>
          <p:nvPr/>
        </p:nvSpPr>
        <p:spPr>
          <a:xfrm>
            <a:off x="5662440" y="2324160"/>
            <a:ext cx="411480" cy="914400"/>
          </a:xfrm>
          <a:custGeom>
            <a:avLst/>
            <a:gdLst/>
            <a:ahLst/>
            <a:rect l="l" t="t" r="r" b="b"/>
            <a:pathLst>
              <a:path w="259" h="576">
                <a:moveTo>
                  <a:pt x="57" y="96"/>
                </a:moveTo>
                <a:cubicBezTo>
                  <a:pt x="50" y="177"/>
                  <a:pt x="35" y="264"/>
                  <a:pt x="9" y="342"/>
                </a:cubicBezTo>
                <a:cubicBezTo>
                  <a:pt x="0" y="413"/>
                  <a:pt x="11" y="480"/>
                  <a:pt x="51" y="540"/>
                </a:cubicBezTo>
                <a:cubicBezTo>
                  <a:pt x="54" y="544"/>
                  <a:pt x="123" y="570"/>
                  <a:pt x="123" y="570"/>
                </a:cubicBezTo>
                <a:cubicBezTo>
                  <a:pt x="129" y="572"/>
                  <a:pt x="141" y="576"/>
                  <a:pt x="141" y="576"/>
                </a:cubicBezTo>
                <a:cubicBezTo>
                  <a:pt x="177" y="571"/>
                  <a:pt x="207" y="566"/>
                  <a:pt x="237" y="546"/>
                </a:cubicBezTo>
                <a:cubicBezTo>
                  <a:pt x="241" y="533"/>
                  <a:pt x="254" y="523"/>
                  <a:pt x="255" y="510"/>
                </a:cubicBezTo>
                <a:cubicBezTo>
                  <a:pt x="259" y="465"/>
                  <a:pt x="230" y="400"/>
                  <a:pt x="219" y="354"/>
                </a:cubicBezTo>
                <a:cubicBezTo>
                  <a:pt x="218" y="327"/>
                  <a:pt x="222" y="243"/>
                  <a:pt x="201" y="204"/>
                </a:cubicBezTo>
                <a:cubicBezTo>
                  <a:pt x="177" y="161"/>
                  <a:pt x="143" y="123"/>
                  <a:pt x="123" y="78"/>
                </a:cubicBezTo>
                <a:cubicBezTo>
                  <a:pt x="109" y="45"/>
                  <a:pt x="107" y="13"/>
                  <a:pt x="69" y="0"/>
                </a:cubicBezTo>
                <a:cubicBezTo>
                  <a:pt x="65" y="12"/>
                  <a:pt x="61" y="24"/>
                  <a:pt x="57" y="36"/>
                </a:cubicBezTo>
                <a:cubicBezTo>
                  <a:pt x="51" y="55"/>
                  <a:pt x="63" y="77"/>
                  <a:pt x="57" y="96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2" name=""/>
          <p:cNvGrpSpPr/>
          <p:nvPr/>
        </p:nvGrpSpPr>
        <p:grpSpPr>
          <a:xfrm>
            <a:off x="1438200" y="2270160"/>
            <a:ext cx="5033520" cy="3368520"/>
            <a:chOff x="1438200" y="2270160"/>
            <a:chExt cx="5033520" cy="3368520"/>
          </a:xfrm>
        </p:grpSpPr>
        <p:sp>
          <p:nvSpPr>
            <p:cNvPr id="203" name=""/>
            <p:cNvSpPr/>
            <p:nvPr/>
          </p:nvSpPr>
          <p:spPr>
            <a:xfrm flipV="1">
              <a:off x="1438200" y="3848040"/>
              <a:ext cx="2660760" cy="1790640"/>
            </a:xfrm>
            <a:prstGeom prst="line">
              <a:avLst/>
            </a:prstGeom>
            <a:ln w="38160">
              <a:solidFill>
                <a:srgbClr val="d8203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4095720" y="3209760"/>
              <a:ext cx="362160" cy="638280"/>
            </a:xfrm>
            <a:custGeom>
              <a:avLst/>
              <a:gdLst/>
              <a:ahLst/>
              <a:rect l="l" t="t" r="r" b="b"/>
              <a:pathLst>
                <a:path w="204" h="360">
                  <a:moveTo>
                    <a:pt x="0" y="360"/>
                  </a:moveTo>
                  <a:cubicBezTo>
                    <a:pt x="34" y="333"/>
                    <a:pt x="68" y="306"/>
                    <a:pt x="90" y="282"/>
                  </a:cubicBezTo>
                  <a:cubicBezTo>
                    <a:pt x="112" y="258"/>
                    <a:pt x="120" y="240"/>
                    <a:pt x="132" y="216"/>
                  </a:cubicBezTo>
                  <a:cubicBezTo>
                    <a:pt x="144" y="192"/>
                    <a:pt x="150" y="174"/>
                    <a:pt x="162" y="138"/>
                  </a:cubicBezTo>
                  <a:cubicBezTo>
                    <a:pt x="174" y="102"/>
                    <a:pt x="189" y="51"/>
                    <a:pt x="204" y="0"/>
                  </a:cubicBezTo>
                </a:path>
              </a:pathLst>
            </a:custGeom>
            <a:noFill/>
            <a:ln w="38160">
              <a:solidFill>
                <a:srgbClr val="d8203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457880" y="2638440"/>
              <a:ext cx="542880" cy="571320"/>
            </a:xfrm>
            <a:custGeom>
              <a:avLst/>
              <a:gdLst/>
              <a:ahLst/>
              <a:rect l="l" t="t" r="r" b="b"/>
              <a:pathLst>
                <a:path w="342" h="360">
                  <a:moveTo>
                    <a:pt x="0" y="360"/>
                  </a:moveTo>
                  <a:cubicBezTo>
                    <a:pt x="7" y="335"/>
                    <a:pt x="14" y="310"/>
                    <a:pt x="24" y="288"/>
                  </a:cubicBezTo>
                  <a:cubicBezTo>
                    <a:pt x="34" y="266"/>
                    <a:pt x="44" y="249"/>
                    <a:pt x="60" y="228"/>
                  </a:cubicBezTo>
                  <a:cubicBezTo>
                    <a:pt x="76" y="207"/>
                    <a:pt x="96" y="185"/>
                    <a:pt x="120" y="162"/>
                  </a:cubicBezTo>
                  <a:cubicBezTo>
                    <a:pt x="144" y="139"/>
                    <a:pt x="167" y="117"/>
                    <a:pt x="204" y="90"/>
                  </a:cubicBezTo>
                  <a:cubicBezTo>
                    <a:pt x="241" y="63"/>
                    <a:pt x="291" y="31"/>
                    <a:pt x="342" y="0"/>
                  </a:cubicBezTo>
                </a:path>
              </a:pathLst>
            </a:custGeom>
            <a:noFill/>
            <a:ln w="38160">
              <a:solidFill>
                <a:srgbClr val="d8203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4981680" y="2270160"/>
              <a:ext cx="799920" cy="377640"/>
            </a:xfrm>
            <a:custGeom>
              <a:avLst/>
              <a:gdLst/>
              <a:ahLst/>
              <a:rect l="l" t="t" r="r" b="b"/>
              <a:pathLst>
                <a:path w="504" h="238">
                  <a:moveTo>
                    <a:pt x="0" y="238"/>
                  </a:moveTo>
                  <a:cubicBezTo>
                    <a:pt x="63" y="195"/>
                    <a:pt x="127" y="153"/>
                    <a:pt x="180" y="118"/>
                  </a:cubicBezTo>
                  <a:cubicBezTo>
                    <a:pt x="233" y="83"/>
                    <a:pt x="285" y="47"/>
                    <a:pt x="318" y="28"/>
                  </a:cubicBezTo>
                  <a:cubicBezTo>
                    <a:pt x="351" y="9"/>
                    <a:pt x="361" y="8"/>
                    <a:pt x="378" y="4"/>
                  </a:cubicBezTo>
                  <a:cubicBezTo>
                    <a:pt x="395" y="0"/>
                    <a:pt x="404" y="1"/>
                    <a:pt x="420" y="4"/>
                  </a:cubicBezTo>
                  <a:cubicBezTo>
                    <a:pt x="436" y="7"/>
                    <a:pt x="460" y="15"/>
                    <a:pt x="474" y="22"/>
                  </a:cubicBezTo>
                  <a:cubicBezTo>
                    <a:pt x="488" y="29"/>
                    <a:pt x="496" y="37"/>
                    <a:pt x="504" y="46"/>
                  </a:cubicBezTo>
                </a:path>
              </a:pathLst>
            </a:custGeom>
            <a:noFill/>
            <a:ln w="38160">
              <a:solidFill>
                <a:srgbClr val="d8203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 rot="21477600">
              <a:off x="5133600" y="2342880"/>
              <a:ext cx="1312920" cy="1423800"/>
            </a:xfrm>
            <a:custGeom>
              <a:avLst/>
              <a:gdLst/>
              <a:ahLst/>
              <a:rect l="l" t="t" r="r" b="b"/>
              <a:pathLst>
                <a:path w="863" h="934">
                  <a:moveTo>
                    <a:pt x="414" y="0"/>
                  </a:moveTo>
                  <a:cubicBezTo>
                    <a:pt x="412" y="6"/>
                    <a:pt x="408" y="12"/>
                    <a:pt x="408" y="18"/>
                  </a:cubicBezTo>
                  <a:cubicBezTo>
                    <a:pt x="408" y="24"/>
                    <a:pt x="415" y="30"/>
                    <a:pt x="414" y="36"/>
                  </a:cubicBezTo>
                  <a:cubicBezTo>
                    <a:pt x="413" y="49"/>
                    <a:pt x="402" y="72"/>
                    <a:pt x="402" y="72"/>
                  </a:cubicBezTo>
                  <a:cubicBezTo>
                    <a:pt x="409" y="106"/>
                    <a:pt x="411" y="98"/>
                    <a:pt x="402" y="132"/>
                  </a:cubicBezTo>
                  <a:cubicBezTo>
                    <a:pt x="399" y="144"/>
                    <a:pt x="394" y="156"/>
                    <a:pt x="390" y="168"/>
                  </a:cubicBezTo>
                  <a:cubicBezTo>
                    <a:pt x="388" y="174"/>
                    <a:pt x="384" y="186"/>
                    <a:pt x="384" y="186"/>
                  </a:cubicBezTo>
                  <a:cubicBezTo>
                    <a:pt x="379" y="229"/>
                    <a:pt x="372" y="270"/>
                    <a:pt x="348" y="306"/>
                  </a:cubicBezTo>
                  <a:cubicBezTo>
                    <a:pt x="350" y="348"/>
                    <a:pt x="349" y="390"/>
                    <a:pt x="354" y="432"/>
                  </a:cubicBezTo>
                  <a:cubicBezTo>
                    <a:pt x="355" y="445"/>
                    <a:pt x="366" y="468"/>
                    <a:pt x="366" y="468"/>
                  </a:cubicBezTo>
                  <a:cubicBezTo>
                    <a:pt x="371" y="511"/>
                    <a:pt x="390" y="572"/>
                    <a:pt x="348" y="600"/>
                  </a:cubicBezTo>
                  <a:cubicBezTo>
                    <a:pt x="340" y="625"/>
                    <a:pt x="313" y="634"/>
                    <a:pt x="288" y="642"/>
                  </a:cubicBezTo>
                  <a:cubicBezTo>
                    <a:pt x="282" y="648"/>
                    <a:pt x="277" y="655"/>
                    <a:pt x="270" y="660"/>
                  </a:cubicBezTo>
                  <a:cubicBezTo>
                    <a:pt x="265" y="664"/>
                    <a:pt x="256" y="662"/>
                    <a:pt x="252" y="666"/>
                  </a:cubicBezTo>
                  <a:cubicBezTo>
                    <a:pt x="227" y="691"/>
                    <a:pt x="226" y="713"/>
                    <a:pt x="198" y="732"/>
                  </a:cubicBezTo>
                  <a:cubicBezTo>
                    <a:pt x="164" y="784"/>
                    <a:pt x="209" y="723"/>
                    <a:pt x="168" y="756"/>
                  </a:cubicBezTo>
                  <a:cubicBezTo>
                    <a:pt x="162" y="761"/>
                    <a:pt x="162" y="770"/>
                    <a:pt x="156" y="774"/>
                  </a:cubicBezTo>
                  <a:cubicBezTo>
                    <a:pt x="139" y="785"/>
                    <a:pt x="105" y="791"/>
                    <a:pt x="84" y="798"/>
                  </a:cubicBezTo>
                  <a:cubicBezTo>
                    <a:pt x="84" y="798"/>
                    <a:pt x="51" y="815"/>
                    <a:pt x="48" y="816"/>
                  </a:cubicBezTo>
                  <a:cubicBezTo>
                    <a:pt x="42" y="825"/>
                    <a:pt x="21" y="856"/>
                    <a:pt x="12" y="870"/>
                  </a:cubicBezTo>
                  <a:cubicBezTo>
                    <a:pt x="8" y="876"/>
                    <a:pt x="0" y="888"/>
                    <a:pt x="0" y="888"/>
                  </a:cubicBezTo>
                  <a:cubicBezTo>
                    <a:pt x="31" y="934"/>
                    <a:pt x="65" y="900"/>
                    <a:pt x="102" y="882"/>
                  </a:cubicBezTo>
                  <a:cubicBezTo>
                    <a:pt x="155" y="855"/>
                    <a:pt x="212" y="833"/>
                    <a:pt x="264" y="804"/>
                  </a:cubicBezTo>
                  <a:cubicBezTo>
                    <a:pt x="295" y="787"/>
                    <a:pt x="320" y="761"/>
                    <a:pt x="354" y="750"/>
                  </a:cubicBezTo>
                  <a:cubicBezTo>
                    <a:pt x="369" y="728"/>
                    <a:pt x="394" y="717"/>
                    <a:pt x="420" y="708"/>
                  </a:cubicBezTo>
                  <a:cubicBezTo>
                    <a:pt x="454" y="656"/>
                    <a:pt x="409" y="717"/>
                    <a:pt x="450" y="684"/>
                  </a:cubicBezTo>
                  <a:cubicBezTo>
                    <a:pt x="456" y="679"/>
                    <a:pt x="456" y="671"/>
                    <a:pt x="462" y="666"/>
                  </a:cubicBezTo>
                  <a:cubicBezTo>
                    <a:pt x="472" y="658"/>
                    <a:pt x="486" y="653"/>
                    <a:pt x="498" y="648"/>
                  </a:cubicBezTo>
                  <a:cubicBezTo>
                    <a:pt x="510" y="643"/>
                    <a:pt x="534" y="636"/>
                    <a:pt x="534" y="636"/>
                  </a:cubicBezTo>
                  <a:cubicBezTo>
                    <a:pt x="538" y="630"/>
                    <a:pt x="540" y="622"/>
                    <a:pt x="546" y="618"/>
                  </a:cubicBezTo>
                  <a:cubicBezTo>
                    <a:pt x="550" y="616"/>
                    <a:pt x="610" y="591"/>
                    <a:pt x="618" y="588"/>
                  </a:cubicBezTo>
                  <a:cubicBezTo>
                    <a:pt x="632" y="567"/>
                    <a:pt x="632" y="554"/>
                    <a:pt x="654" y="540"/>
                  </a:cubicBezTo>
                  <a:cubicBezTo>
                    <a:pt x="680" y="500"/>
                    <a:pt x="735" y="487"/>
                    <a:pt x="780" y="474"/>
                  </a:cubicBezTo>
                  <a:cubicBezTo>
                    <a:pt x="800" y="468"/>
                    <a:pt x="834" y="444"/>
                    <a:pt x="834" y="444"/>
                  </a:cubicBezTo>
                  <a:cubicBezTo>
                    <a:pt x="863" y="401"/>
                    <a:pt x="861" y="335"/>
                    <a:pt x="828" y="294"/>
                  </a:cubicBezTo>
                  <a:cubicBezTo>
                    <a:pt x="814" y="276"/>
                    <a:pt x="786" y="279"/>
                    <a:pt x="768" y="276"/>
                  </a:cubicBezTo>
                  <a:cubicBezTo>
                    <a:pt x="765" y="276"/>
                    <a:pt x="649" y="290"/>
                    <a:pt x="618" y="276"/>
                  </a:cubicBezTo>
                  <a:cubicBezTo>
                    <a:pt x="601" y="269"/>
                    <a:pt x="590" y="219"/>
                    <a:pt x="582" y="204"/>
                  </a:cubicBezTo>
                  <a:cubicBezTo>
                    <a:pt x="562" y="167"/>
                    <a:pt x="543" y="157"/>
                    <a:pt x="504" y="144"/>
                  </a:cubicBezTo>
                  <a:cubicBezTo>
                    <a:pt x="490" y="122"/>
                    <a:pt x="479" y="96"/>
                    <a:pt x="468" y="72"/>
                  </a:cubicBezTo>
                  <a:cubicBezTo>
                    <a:pt x="447" y="25"/>
                    <a:pt x="470" y="46"/>
                    <a:pt x="438" y="24"/>
                  </a:cubicBezTo>
                  <a:cubicBezTo>
                    <a:pt x="424" y="2"/>
                    <a:pt x="432" y="9"/>
                    <a:pt x="414" y="0"/>
                  </a:cubicBezTo>
                  <a:close/>
                </a:path>
              </a:pathLst>
            </a:custGeom>
            <a:gradFill rotWithShape="0">
              <a:gsLst>
                <a:gs pos="0">
                  <a:srgbClr val="d82036"/>
                </a:gs>
                <a:gs pos="50000">
                  <a:srgbClr val="630e18"/>
                </a:gs>
                <a:gs pos="100000">
                  <a:srgbClr val="d82036"/>
                </a:gs>
              </a:gsLst>
              <a:lin ang="8226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8" name=""/>
          <p:cNvSpPr/>
          <p:nvPr/>
        </p:nvSpPr>
        <p:spPr>
          <a:xfrm>
            <a:off x="6026040" y="29224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rot="1174800">
            <a:off x="5749920" y="31744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5764320" y="2360520"/>
            <a:ext cx="4608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rot="3177000">
            <a:off x="5392800" y="348948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rot="19968000">
            <a:off x="5764320" y="264600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rot="1428600">
            <a:off x="6178680" y="28461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rot="19675200">
            <a:off x="5807160" y="28461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 rot="1783800">
            <a:off x="5949720" y="27748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rot="4383600">
            <a:off x="5577120" y="331848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rot="1726200">
            <a:off x="5870520" y="3083040"/>
            <a:ext cx="46080" cy="2840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2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9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220" name=""/>
          <p:cNvSpPr/>
          <p:nvPr/>
        </p:nvSpPr>
        <p:spPr>
          <a:xfrm>
            <a:off x="4832280" y="2832120"/>
            <a:ext cx="19548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 flipV="1">
            <a:off x="2419200" y="3400200"/>
            <a:ext cx="220356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624560" y="3036960"/>
            <a:ext cx="20772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5202360" y="2575080"/>
            <a:ext cx="287280" cy="1364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 flipV="1">
            <a:off x="5019840" y="2707920"/>
            <a:ext cx="188640" cy="1285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rot="21477600">
            <a:off x="5154480" y="2590920"/>
            <a:ext cx="722520" cy="744480"/>
          </a:xfrm>
          <a:custGeom>
            <a:avLst/>
            <a:gdLst/>
            <a:ahLst/>
            <a:rect l="l" t="t" r="r" b="b"/>
            <a:pathLst>
              <a:path w="863" h="934">
                <a:moveTo>
                  <a:pt x="414" y="0"/>
                </a:moveTo>
                <a:cubicBezTo>
                  <a:pt x="412" y="6"/>
                  <a:pt x="408" y="12"/>
                  <a:pt x="408" y="18"/>
                </a:cubicBezTo>
                <a:cubicBezTo>
                  <a:pt x="408" y="24"/>
                  <a:pt x="415" y="30"/>
                  <a:pt x="414" y="36"/>
                </a:cubicBezTo>
                <a:cubicBezTo>
                  <a:pt x="413" y="49"/>
                  <a:pt x="402" y="72"/>
                  <a:pt x="402" y="72"/>
                </a:cubicBezTo>
                <a:cubicBezTo>
                  <a:pt x="409" y="106"/>
                  <a:pt x="411" y="98"/>
                  <a:pt x="402" y="132"/>
                </a:cubicBezTo>
                <a:cubicBezTo>
                  <a:pt x="399" y="144"/>
                  <a:pt x="394" y="156"/>
                  <a:pt x="390" y="168"/>
                </a:cubicBezTo>
                <a:cubicBezTo>
                  <a:pt x="388" y="174"/>
                  <a:pt x="384" y="186"/>
                  <a:pt x="384" y="186"/>
                </a:cubicBezTo>
                <a:cubicBezTo>
                  <a:pt x="379" y="229"/>
                  <a:pt x="372" y="270"/>
                  <a:pt x="348" y="306"/>
                </a:cubicBezTo>
                <a:cubicBezTo>
                  <a:pt x="350" y="348"/>
                  <a:pt x="349" y="390"/>
                  <a:pt x="354" y="432"/>
                </a:cubicBezTo>
                <a:cubicBezTo>
                  <a:pt x="355" y="445"/>
                  <a:pt x="366" y="468"/>
                  <a:pt x="366" y="468"/>
                </a:cubicBezTo>
                <a:cubicBezTo>
                  <a:pt x="371" y="511"/>
                  <a:pt x="390" y="572"/>
                  <a:pt x="348" y="600"/>
                </a:cubicBezTo>
                <a:cubicBezTo>
                  <a:pt x="340" y="625"/>
                  <a:pt x="313" y="634"/>
                  <a:pt x="288" y="642"/>
                </a:cubicBezTo>
                <a:cubicBezTo>
                  <a:pt x="282" y="648"/>
                  <a:pt x="277" y="655"/>
                  <a:pt x="270" y="660"/>
                </a:cubicBezTo>
                <a:cubicBezTo>
                  <a:pt x="265" y="664"/>
                  <a:pt x="256" y="662"/>
                  <a:pt x="252" y="666"/>
                </a:cubicBezTo>
                <a:cubicBezTo>
                  <a:pt x="227" y="691"/>
                  <a:pt x="226" y="713"/>
                  <a:pt x="198" y="732"/>
                </a:cubicBezTo>
                <a:cubicBezTo>
                  <a:pt x="164" y="784"/>
                  <a:pt x="209" y="723"/>
                  <a:pt x="168" y="756"/>
                </a:cubicBezTo>
                <a:cubicBezTo>
                  <a:pt x="162" y="761"/>
                  <a:pt x="162" y="770"/>
                  <a:pt x="156" y="774"/>
                </a:cubicBezTo>
                <a:cubicBezTo>
                  <a:pt x="139" y="785"/>
                  <a:pt x="105" y="791"/>
                  <a:pt x="84" y="798"/>
                </a:cubicBezTo>
                <a:cubicBezTo>
                  <a:pt x="84" y="798"/>
                  <a:pt x="51" y="815"/>
                  <a:pt x="48" y="816"/>
                </a:cubicBezTo>
                <a:cubicBezTo>
                  <a:pt x="42" y="825"/>
                  <a:pt x="21" y="856"/>
                  <a:pt x="12" y="870"/>
                </a:cubicBezTo>
                <a:cubicBezTo>
                  <a:pt x="8" y="876"/>
                  <a:pt x="0" y="888"/>
                  <a:pt x="0" y="888"/>
                </a:cubicBezTo>
                <a:cubicBezTo>
                  <a:pt x="31" y="934"/>
                  <a:pt x="65" y="900"/>
                  <a:pt x="102" y="882"/>
                </a:cubicBezTo>
                <a:cubicBezTo>
                  <a:pt x="155" y="855"/>
                  <a:pt x="212" y="833"/>
                  <a:pt x="264" y="804"/>
                </a:cubicBezTo>
                <a:cubicBezTo>
                  <a:pt x="295" y="787"/>
                  <a:pt x="320" y="761"/>
                  <a:pt x="354" y="750"/>
                </a:cubicBezTo>
                <a:cubicBezTo>
                  <a:pt x="369" y="728"/>
                  <a:pt x="394" y="717"/>
                  <a:pt x="420" y="708"/>
                </a:cubicBezTo>
                <a:cubicBezTo>
                  <a:pt x="454" y="656"/>
                  <a:pt x="409" y="717"/>
                  <a:pt x="450" y="684"/>
                </a:cubicBezTo>
                <a:cubicBezTo>
                  <a:pt x="456" y="679"/>
                  <a:pt x="456" y="671"/>
                  <a:pt x="462" y="666"/>
                </a:cubicBezTo>
                <a:cubicBezTo>
                  <a:pt x="472" y="658"/>
                  <a:pt x="486" y="653"/>
                  <a:pt x="498" y="648"/>
                </a:cubicBezTo>
                <a:cubicBezTo>
                  <a:pt x="510" y="643"/>
                  <a:pt x="534" y="636"/>
                  <a:pt x="534" y="636"/>
                </a:cubicBezTo>
                <a:cubicBezTo>
                  <a:pt x="538" y="630"/>
                  <a:pt x="540" y="622"/>
                  <a:pt x="546" y="618"/>
                </a:cubicBezTo>
                <a:cubicBezTo>
                  <a:pt x="550" y="616"/>
                  <a:pt x="610" y="591"/>
                  <a:pt x="618" y="588"/>
                </a:cubicBezTo>
                <a:cubicBezTo>
                  <a:pt x="632" y="567"/>
                  <a:pt x="632" y="554"/>
                  <a:pt x="654" y="540"/>
                </a:cubicBezTo>
                <a:cubicBezTo>
                  <a:pt x="680" y="500"/>
                  <a:pt x="735" y="487"/>
                  <a:pt x="780" y="474"/>
                </a:cubicBezTo>
                <a:cubicBezTo>
                  <a:pt x="800" y="468"/>
                  <a:pt x="834" y="444"/>
                  <a:pt x="834" y="444"/>
                </a:cubicBezTo>
                <a:cubicBezTo>
                  <a:pt x="863" y="401"/>
                  <a:pt x="861" y="335"/>
                  <a:pt x="828" y="294"/>
                </a:cubicBezTo>
                <a:cubicBezTo>
                  <a:pt x="814" y="276"/>
                  <a:pt x="786" y="279"/>
                  <a:pt x="768" y="276"/>
                </a:cubicBezTo>
                <a:cubicBezTo>
                  <a:pt x="765" y="276"/>
                  <a:pt x="649" y="290"/>
                  <a:pt x="618" y="276"/>
                </a:cubicBezTo>
                <a:cubicBezTo>
                  <a:pt x="601" y="269"/>
                  <a:pt x="590" y="219"/>
                  <a:pt x="582" y="204"/>
                </a:cubicBezTo>
                <a:cubicBezTo>
                  <a:pt x="562" y="167"/>
                  <a:pt x="543" y="157"/>
                  <a:pt x="504" y="144"/>
                </a:cubicBezTo>
                <a:cubicBezTo>
                  <a:pt x="490" y="122"/>
                  <a:pt x="479" y="96"/>
                  <a:pt x="468" y="72"/>
                </a:cubicBezTo>
                <a:cubicBezTo>
                  <a:pt x="447" y="25"/>
                  <a:pt x="470" y="46"/>
                  <a:pt x="438" y="24"/>
                </a:cubicBezTo>
                <a:cubicBezTo>
                  <a:pt x="424" y="2"/>
                  <a:pt x="432" y="9"/>
                  <a:pt x="414" y="0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50000">
                <a:srgbClr val="630e18"/>
              </a:gs>
              <a:gs pos="100000">
                <a:srgbClr val="d82036"/>
              </a:gs>
            </a:gsLst>
            <a:lin ang="8226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5583240" y="28512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5504040" y="2857680"/>
            <a:ext cx="4572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 rot="3177000">
            <a:off x="5263560" y="313236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rot="19968000">
            <a:off x="5481720" y="261576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 rot="1428600">
            <a:off x="5686560" y="281592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rot="19675200">
            <a:off x="5607000" y="27172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rot="3850800">
            <a:off x="5448600" y="300420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3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 advTm="1000">
    <p:fade/>
  </p:transition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4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235" name=""/>
          <p:cNvSpPr/>
          <p:nvPr/>
        </p:nvSpPr>
        <p:spPr>
          <a:xfrm>
            <a:off x="4975200" y="2736720"/>
            <a:ext cx="19512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 flipV="1">
            <a:off x="2562120" y="3304800"/>
            <a:ext cx="220356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4767120" y="2941560"/>
            <a:ext cx="20808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5345280" y="2479680"/>
            <a:ext cx="287280" cy="1364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 flipV="1">
            <a:off x="5162400" y="2612880"/>
            <a:ext cx="189000" cy="1288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 rot="339600">
            <a:off x="5027400" y="2465280"/>
            <a:ext cx="738000" cy="839880"/>
          </a:xfrm>
          <a:custGeom>
            <a:avLst/>
            <a:gdLst/>
            <a:ahLst/>
            <a:rect l="l" t="t" r="r" b="b"/>
            <a:pathLst>
              <a:path w="579" h="486">
                <a:moveTo>
                  <a:pt x="429" y="0"/>
                </a:moveTo>
                <a:cubicBezTo>
                  <a:pt x="481" y="17"/>
                  <a:pt x="425" y="85"/>
                  <a:pt x="477" y="102"/>
                </a:cubicBezTo>
                <a:cubicBezTo>
                  <a:pt x="518" y="164"/>
                  <a:pt x="461" y="179"/>
                  <a:pt x="423" y="204"/>
                </a:cubicBezTo>
                <a:cubicBezTo>
                  <a:pt x="419" y="216"/>
                  <a:pt x="415" y="228"/>
                  <a:pt x="411" y="240"/>
                </a:cubicBezTo>
                <a:cubicBezTo>
                  <a:pt x="409" y="246"/>
                  <a:pt x="405" y="258"/>
                  <a:pt x="405" y="258"/>
                </a:cubicBezTo>
                <a:cubicBezTo>
                  <a:pt x="411" y="276"/>
                  <a:pt x="415" y="276"/>
                  <a:pt x="405" y="294"/>
                </a:cubicBezTo>
                <a:cubicBezTo>
                  <a:pt x="398" y="307"/>
                  <a:pt x="395" y="325"/>
                  <a:pt x="381" y="330"/>
                </a:cubicBezTo>
                <a:cubicBezTo>
                  <a:pt x="365" y="335"/>
                  <a:pt x="325" y="343"/>
                  <a:pt x="309" y="354"/>
                </a:cubicBezTo>
                <a:cubicBezTo>
                  <a:pt x="293" y="365"/>
                  <a:pt x="255" y="378"/>
                  <a:pt x="255" y="378"/>
                </a:cubicBezTo>
                <a:cubicBezTo>
                  <a:pt x="219" y="369"/>
                  <a:pt x="239" y="375"/>
                  <a:pt x="195" y="360"/>
                </a:cubicBezTo>
                <a:cubicBezTo>
                  <a:pt x="183" y="356"/>
                  <a:pt x="159" y="348"/>
                  <a:pt x="159" y="348"/>
                </a:cubicBezTo>
                <a:cubicBezTo>
                  <a:pt x="131" y="353"/>
                  <a:pt x="89" y="358"/>
                  <a:pt x="63" y="372"/>
                </a:cubicBezTo>
                <a:cubicBezTo>
                  <a:pt x="50" y="379"/>
                  <a:pt x="39" y="388"/>
                  <a:pt x="27" y="396"/>
                </a:cubicBezTo>
                <a:cubicBezTo>
                  <a:pt x="21" y="400"/>
                  <a:pt x="9" y="408"/>
                  <a:pt x="9" y="408"/>
                </a:cubicBezTo>
                <a:cubicBezTo>
                  <a:pt x="11" y="414"/>
                  <a:pt x="0" y="390"/>
                  <a:pt x="15" y="426"/>
                </a:cubicBezTo>
                <a:lnTo>
                  <a:pt x="27" y="462"/>
                </a:lnTo>
                <a:lnTo>
                  <a:pt x="93" y="486"/>
                </a:lnTo>
                <a:lnTo>
                  <a:pt x="159" y="486"/>
                </a:lnTo>
                <a:lnTo>
                  <a:pt x="219" y="456"/>
                </a:lnTo>
                <a:lnTo>
                  <a:pt x="321" y="402"/>
                </a:lnTo>
                <a:lnTo>
                  <a:pt x="501" y="282"/>
                </a:lnTo>
                <a:lnTo>
                  <a:pt x="573" y="210"/>
                </a:lnTo>
                <a:lnTo>
                  <a:pt x="579" y="156"/>
                </a:lnTo>
                <a:lnTo>
                  <a:pt x="531" y="102"/>
                </a:lnTo>
                <a:lnTo>
                  <a:pt x="507" y="72"/>
                </a:lnTo>
                <a:lnTo>
                  <a:pt x="495" y="24"/>
                </a:lnTo>
                <a:lnTo>
                  <a:pt x="465" y="0"/>
                </a:lnTo>
                <a:lnTo>
                  <a:pt x="429" y="0"/>
                </a:ln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058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rot="3241800">
            <a:off x="5397480" y="30081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5689440" y="2671920"/>
            <a:ext cx="4608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 rot="19968000">
            <a:off x="5653080" y="253008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rot="1428600">
            <a:off x="5586120" y="280152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 rot="4360200">
            <a:off x="5135040" y="303192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 rot="5400000">
            <a:off x="5134320" y="308988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4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8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249" name=""/>
          <p:cNvSpPr/>
          <p:nvPr/>
        </p:nvSpPr>
        <p:spPr>
          <a:xfrm>
            <a:off x="5156280" y="2622600"/>
            <a:ext cx="19512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V="1">
            <a:off x="2743200" y="3190680"/>
            <a:ext cx="220356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4948200" y="2827440"/>
            <a:ext cx="20808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5526000" y="2365200"/>
            <a:ext cx="287280" cy="13680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V="1">
            <a:off x="5343480" y="2498400"/>
            <a:ext cx="189000" cy="1285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157720" y="2390760"/>
            <a:ext cx="862200" cy="819000"/>
          </a:xfrm>
          <a:custGeom>
            <a:avLst/>
            <a:gdLst/>
            <a:ahLst/>
            <a:rect l="l" t="t" r="r" b="b"/>
            <a:pathLst>
              <a:path w="579" h="486">
                <a:moveTo>
                  <a:pt x="429" y="0"/>
                </a:moveTo>
                <a:cubicBezTo>
                  <a:pt x="481" y="17"/>
                  <a:pt x="425" y="85"/>
                  <a:pt x="477" y="102"/>
                </a:cubicBezTo>
                <a:cubicBezTo>
                  <a:pt x="518" y="164"/>
                  <a:pt x="461" y="179"/>
                  <a:pt x="423" y="204"/>
                </a:cubicBezTo>
                <a:cubicBezTo>
                  <a:pt x="419" y="216"/>
                  <a:pt x="415" y="228"/>
                  <a:pt x="411" y="240"/>
                </a:cubicBezTo>
                <a:cubicBezTo>
                  <a:pt x="409" y="246"/>
                  <a:pt x="405" y="258"/>
                  <a:pt x="405" y="258"/>
                </a:cubicBezTo>
                <a:cubicBezTo>
                  <a:pt x="411" y="276"/>
                  <a:pt x="415" y="276"/>
                  <a:pt x="405" y="294"/>
                </a:cubicBezTo>
                <a:cubicBezTo>
                  <a:pt x="398" y="307"/>
                  <a:pt x="395" y="325"/>
                  <a:pt x="381" y="330"/>
                </a:cubicBezTo>
                <a:cubicBezTo>
                  <a:pt x="365" y="335"/>
                  <a:pt x="325" y="343"/>
                  <a:pt x="309" y="354"/>
                </a:cubicBezTo>
                <a:cubicBezTo>
                  <a:pt x="293" y="365"/>
                  <a:pt x="255" y="378"/>
                  <a:pt x="255" y="378"/>
                </a:cubicBezTo>
                <a:cubicBezTo>
                  <a:pt x="219" y="369"/>
                  <a:pt x="239" y="375"/>
                  <a:pt x="195" y="360"/>
                </a:cubicBezTo>
                <a:cubicBezTo>
                  <a:pt x="183" y="356"/>
                  <a:pt x="159" y="348"/>
                  <a:pt x="159" y="348"/>
                </a:cubicBezTo>
                <a:cubicBezTo>
                  <a:pt x="131" y="353"/>
                  <a:pt x="89" y="358"/>
                  <a:pt x="63" y="372"/>
                </a:cubicBezTo>
                <a:cubicBezTo>
                  <a:pt x="50" y="379"/>
                  <a:pt x="39" y="388"/>
                  <a:pt x="27" y="396"/>
                </a:cubicBezTo>
                <a:cubicBezTo>
                  <a:pt x="21" y="400"/>
                  <a:pt x="9" y="408"/>
                  <a:pt x="9" y="408"/>
                </a:cubicBezTo>
                <a:cubicBezTo>
                  <a:pt x="11" y="414"/>
                  <a:pt x="0" y="390"/>
                  <a:pt x="15" y="426"/>
                </a:cubicBezTo>
                <a:lnTo>
                  <a:pt x="27" y="462"/>
                </a:lnTo>
                <a:lnTo>
                  <a:pt x="93" y="486"/>
                </a:lnTo>
                <a:lnTo>
                  <a:pt x="159" y="486"/>
                </a:lnTo>
                <a:lnTo>
                  <a:pt x="219" y="456"/>
                </a:lnTo>
                <a:lnTo>
                  <a:pt x="321" y="402"/>
                </a:lnTo>
                <a:lnTo>
                  <a:pt x="501" y="282"/>
                </a:lnTo>
                <a:lnTo>
                  <a:pt x="573" y="210"/>
                </a:lnTo>
                <a:lnTo>
                  <a:pt x="579" y="156"/>
                </a:lnTo>
                <a:lnTo>
                  <a:pt x="531" y="102"/>
                </a:lnTo>
                <a:lnTo>
                  <a:pt x="507" y="72"/>
                </a:lnTo>
                <a:lnTo>
                  <a:pt x="495" y="24"/>
                </a:lnTo>
                <a:lnTo>
                  <a:pt x="465" y="0"/>
                </a:lnTo>
                <a:lnTo>
                  <a:pt x="429" y="0"/>
                </a:ln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5940360" y="26370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5861160" y="2643120"/>
            <a:ext cx="4608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 rot="3177000">
            <a:off x="5621400" y="29178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 rot="19968000">
            <a:off x="5838840" y="240156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rot="6638400">
            <a:off x="5285880" y="304452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 rot="19675200">
            <a:off x="5392800" y="298908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rot="3850800">
            <a:off x="5805720" y="279000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5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3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264" name=""/>
          <p:cNvSpPr/>
          <p:nvPr/>
        </p:nvSpPr>
        <p:spPr>
          <a:xfrm>
            <a:off x="5299200" y="2527200"/>
            <a:ext cx="19512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 flipV="1">
            <a:off x="2886120" y="3095280"/>
            <a:ext cx="220356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5091120" y="2732040"/>
            <a:ext cx="20808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5668920" y="2270160"/>
            <a:ext cx="287280" cy="1364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 flipV="1">
            <a:off x="5486400" y="2403360"/>
            <a:ext cx="189000" cy="1288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5310360" y="2284560"/>
            <a:ext cx="917280" cy="763560"/>
          </a:xfrm>
          <a:custGeom>
            <a:avLst/>
            <a:gdLst/>
            <a:ahLst/>
            <a:rect l="l" t="t" r="r" b="b"/>
            <a:pathLst>
              <a:path w="638" h="529">
                <a:moveTo>
                  <a:pt x="441" y="1"/>
                </a:moveTo>
                <a:cubicBezTo>
                  <a:pt x="446" y="76"/>
                  <a:pt x="435" y="79"/>
                  <a:pt x="477" y="121"/>
                </a:cubicBezTo>
                <a:cubicBezTo>
                  <a:pt x="471" y="151"/>
                  <a:pt x="454" y="177"/>
                  <a:pt x="423" y="187"/>
                </a:cubicBezTo>
                <a:cubicBezTo>
                  <a:pt x="415" y="210"/>
                  <a:pt x="398" y="294"/>
                  <a:pt x="381" y="307"/>
                </a:cubicBezTo>
                <a:cubicBezTo>
                  <a:pt x="376" y="311"/>
                  <a:pt x="369" y="310"/>
                  <a:pt x="363" y="313"/>
                </a:cubicBezTo>
                <a:cubicBezTo>
                  <a:pt x="332" y="330"/>
                  <a:pt x="307" y="350"/>
                  <a:pt x="273" y="361"/>
                </a:cubicBezTo>
                <a:cubicBezTo>
                  <a:pt x="211" y="356"/>
                  <a:pt x="159" y="340"/>
                  <a:pt x="99" y="331"/>
                </a:cubicBezTo>
                <a:cubicBezTo>
                  <a:pt x="91" y="333"/>
                  <a:pt x="83" y="335"/>
                  <a:pt x="75" y="337"/>
                </a:cubicBezTo>
                <a:cubicBezTo>
                  <a:pt x="63" y="341"/>
                  <a:pt x="39" y="349"/>
                  <a:pt x="39" y="349"/>
                </a:cubicBezTo>
                <a:cubicBezTo>
                  <a:pt x="31" y="361"/>
                  <a:pt x="20" y="371"/>
                  <a:pt x="15" y="385"/>
                </a:cubicBezTo>
                <a:cubicBezTo>
                  <a:pt x="11" y="397"/>
                  <a:pt x="3" y="421"/>
                  <a:pt x="3" y="421"/>
                </a:cubicBezTo>
                <a:cubicBezTo>
                  <a:pt x="6" y="439"/>
                  <a:pt x="0" y="464"/>
                  <a:pt x="15" y="475"/>
                </a:cubicBezTo>
                <a:cubicBezTo>
                  <a:pt x="42" y="495"/>
                  <a:pt x="91" y="497"/>
                  <a:pt x="123" y="505"/>
                </a:cubicBezTo>
                <a:cubicBezTo>
                  <a:pt x="123" y="505"/>
                  <a:pt x="168" y="520"/>
                  <a:pt x="177" y="523"/>
                </a:cubicBezTo>
                <a:cubicBezTo>
                  <a:pt x="183" y="525"/>
                  <a:pt x="195" y="529"/>
                  <a:pt x="195" y="529"/>
                </a:cubicBezTo>
                <a:cubicBezTo>
                  <a:pt x="207" y="525"/>
                  <a:pt x="219" y="521"/>
                  <a:pt x="231" y="517"/>
                </a:cubicBezTo>
                <a:cubicBezTo>
                  <a:pt x="245" y="512"/>
                  <a:pt x="253" y="498"/>
                  <a:pt x="267" y="493"/>
                </a:cubicBezTo>
                <a:cubicBezTo>
                  <a:pt x="299" y="482"/>
                  <a:pt x="328" y="467"/>
                  <a:pt x="357" y="451"/>
                </a:cubicBezTo>
                <a:cubicBezTo>
                  <a:pt x="419" y="417"/>
                  <a:pt x="370" y="435"/>
                  <a:pt x="411" y="421"/>
                </a:cubicBezTo>
                <a:cubicBezTo>
                  <a:pt x="421" y="390"/>
                  <a:pt x="449" y="351"/>
                  <a:pt x="483" y="343"/>
                </a:cubicBezTo>
                <a:cubicBezTo>
                  <a:pt x="503" y="338"/>
                  <a:pt x="543" y="325"/>
                  <a:pt x="543" y="325"/>
                </a:cubicBezTo>
                <a:cubicBezTo>
                  <a:pt x="557" y="282"/>
                  <a:pt x="537" y="334"/>
                  <a:pt x="567" y="289"/>
                </a:cubicBezTo>
                <a:cubicBezTo>
                  <a:pt x="571" y="284"/>
                  <a:pt x="569" y="275"/>
                  <a:pt x="573" y="271"/>
                </a:cubicBezTo>
                <a:cubicBezTo>
                  <a:pt x="583" y="261"/>
                  <a:pt x="609" y="247"/>
                  <a:pt x="609" y="247"/>
                </a:cubicBezTo>
                <a:cubicBezTo>
                  <a:pt x="631" y="203"/>
                  <a:pt x="638" y="200"/>
                  <a:pt x="585" y="187"/>
                </a:cubicBezTo>
                <a:cubicBezTo>
                  <a:pt x="571" y="177"/>
                  <a:pt x="555" y="169"/>
                  <a:pt x="543" y="157"/>
                </a:cubicBezTo>
                <a:cubicBezTo>
                  <a:pt x="524" y="138"/>
                  <a:pt x="530" y="125"/>
                  <a:pt x="507" y="109"/>
                </a:cubicBezTo>
                <a:cubicBezTo>
                  <a:pt x="503" y="95"/>
                  <a:pt x="497" y="81"/>
                  <a:pt x="495" y="67"/>
                </a:cubicBezTo>
                <a:cubicBezTo>
                  <a:pt x="492" y="49"/>
                  <a:pt x="499" y="28"/>
                  <a:pt x="489" y="13"/>
                </a:cubicBezTo>
                <a:cubicBezTo>
                  <a:pt x="481" y="0"/>
                  <a:pt x="456" y="1"/>
                  <a:pt x="441" y="1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6068880" y="250812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5989680" y="2543040"/>
            <a:ext cx="46080" cy="136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 rot="3177000">
            <a:off x="5720760" y="28036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rot="19968000">
            <a:off x="5967360" y="230148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rot="18123600">
            <a:off x="5400360" y="283032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rot="15939000">
            <a:off x="5549760" y="277452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 rot="3850800">
            <a:off x="5891400" y="264708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6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8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279" name=""/>
          <p:cNvSpPr/>
          <p:nvPr/>
        </p:nvSpPr>
        <p:spPr>
          <a:xfrm>
            <a:off x="5442120" y="2432160"/>
            <a:ext cx="19512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 flipV="1">
            <a:off x="3029040" y="2999880"/>
            <a:ext cx="220320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5234040" y="2637000"/>
            <a:ext cx="208080" cy="36324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5811840" y="2174760"/>
            <a:ext cx="287280" cy="13680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 flipV="1">
            <a:off x="5629320" y="2307960"/>
            <a:ext cx="189000" cy="1285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5452920" y="2174760"/>
            <a:ext cx="917640" cy="763560"/>
          </a:xfrm>
          <a:custGeom>
            <a:avLst/>
            <a:gdLst/>
            <a:ahLst/>
            <a:rect l="l" t="t" r="r" b="b"/>
            <a:pathLst>
              <a:path w="638" h="529">
                <a:moveTo>
                  <a:pt x="441" y="1"/>
                </a:moveTo>
                <a:cubicBezTo>
                  <a:pt x="446" y="76"/>
                  <a:pt x="435" y="79"/>
                  <a:pt x="477" y="121"/>
                </a:cubicBezTo>
                <a:cubicBezTo>
                  <a:pt x="471" y="151"/>
                  <a:pt x="454" y="177"/>
                  <a:pt x="423" y="187"/>
                </a:cubicBezTo>
                <a:cubicBezTo>
                  <a:pt x="415" y="210"/>
                  <a:pt x="398" y="294"/>
                  <a:pt x="381" y="307"/>
                </a:cubicBezTo>
                <a:cubicBezTo>
                  <a:pt x="376" y="311"/>
                  <a:pt x="369" y="310"/>
                  <a:pt x="363" y="313"/>
                </a:cubicBezTo>
                <a:cubicBezTo>
                  <a:pt x="332" y="330"/>
                  <a:pt x="307" y="350"/>
                  <a:pt x="273" y="361"/>
                </a:cubicBezTo>
                <a:cubicBezTo>
                  <a:pt x="211" y="356"/>
                  <a:pt x="159" y="340"/>
                  <a:pt x="99" y="331"/>
                </a:cubicBezTo>
                <a:cubicBezTo>
                  <a:pt x="91" y="333"/>
                  <a:pt x="83" y="335"/>
                  <a:pt x="75" y="337"/>
                </a:cubicBezTo>
                <a:cubicBezTo>
                  <a:pt x="63" y="341"/>
                  <a:pt x="39" y="349"/>
                  <a:pt x="39" y="349"/>
                </a:cubicBezTo>
                <a:cubicBezTo>
                  <a:pt x="31" y="361"/>
                  <a:pt x="20" y="371"/>
                  <a:pt x="15" y="385"/>
                </a:cubicBezTo>
                <a:cubicBezTo>
                  <a:pt x="11" y="397"/>
                  <a:pt x="3" y="421"/>
                  <a:pt x="3" y="421"/>
                </a:cubicBezTo>
                <a:cubicBezTo>
                  <a:pt x="6" y="439"/>
                  <a:pt x="0" y="464"/>
                  <a:pt x="15" y="475"/>
                </a:cubicBezTo>
                <a:cubicBezTo>
                  <a:pt x="42" y="495"/>
                  <a:pt x="91" y="497"/>
                  <a:pt x="123" y="505"/>
                </a:cubicBezTo>
                <a:cubicBezTo>
                  <a:pt x="123" y="505"/>
                  <a:pt x="168" y="520"/>
                  <a:pt x="177" y="523"/>
                </a:cubicBezTo>
                <a:cubicBezTo>
                  <a:pt x="183" y="525"/>
                  <a:pt x="195" y="529"/>
                  <a:pt x="195" y="529"/>
                </a:cubicBezTo>
                <a:cubicBezTo>
                  <a:pt x="207" y="525"/>
                  <a:pt x="219" y="521"/>
                  <a:pt x="231" y="517"/>
                </a:cubicBezTo>
                <a:cubicBezTo>
                  <a:pt x="245" y="512"/>
                  <a:pt x="253" y="498"/>
                  <a:pt x="267" y="493"/>
                </a:cubicBezTo>
                <a:cubicBezTo>
                  <a:pt x="299" y="482"/>
                  <a:pt x="328" y="467"/>
                  <a:pt x="357" y="451"/>
                </a:cubicBezTo>
                <a:cubicBezTo>
                  <a:pt x="419" y="417"/>
                  <a:pt x="370" y="435"/>
                  <a:pt x="411" y="421"/>
                </a:cubicBezTo>
                <a:cubicBezTo>
                  <a:pt x="421" y="390"/>
                  <a:pt x="449" y="351"/>
                  <a:pt x="483" y="343"/>
                </a:cubicBezTo>
                <a:cubicBezTo>
                  <a:pt x="503" y="338"/>
                  <a:pt x="543" y="325"/>
                  <a:pt x="543" y="325"/>
                </a:cubicBezTo>
                <a:cubicBezTo>
                  <a:pt x="557" y="282"/>
                  <a:pt x="537" y="334"/>
                  <a:pt x="567" y="289"/>
                </a:cubicBezTo>
                <a:cubicBezTo>
                  <a:pt x="571" y="284"/>
                  <a:pt x="569" y="275"/>
                  <a:pt x="573" y="271"/>
                </a:cubicBezTo>
                <a:cubicBezTo>
                  <a:pt x="583" y="261"/>
                  <a:pt x="609" y="247"/>
                  <a:pt x="609" y="247"/>
                </a:cubicBezTo>
                <a:cubicBezTo>
                  <a:pt x="631" y="203"/>
                  <a:pt x="638" y="200"/>
                  <a:pt x="585" y="187"/>
                </a:cubicBezTo>
                <a:cubicBezTo>
                  <a:pt x="571" y="177"/>
                  <a:pt x="555" y="169"/>
                  <a:pt x="543" y="157"/>
                </a:cubicBezTo>
                <a:cubicBezTo>
                  <a:pt x="524" y="138"/>
                  <a:pt x="530" y="125"/>
                  <a:pt x="507" y="109"/>
                </a:cubicBezTo>
                <a:cubicBezTo>
                  <a:pt x="503" y="95"/>
                  <a:pt x="497" y="81"/>
                  <a:pt x="495" y="67"/>
                </a:cubicBezTo>
                <a:cubicBezTo>
                  <a:pt x="492" y="49"/>
                  <a:pt x="499" y="28"/>
                  <a:pt x="489" y="13"/>
                </a:cubicBezTo>
                <a:cubicBezTo>
                  <a:pt x="481" y="0"/>
                  <a:pt x="456" y="1"/>
                  <a:pt x="441" y="1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6211800" y="24368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 rot="18890400">
            <a:off x="6118920" y="2470680"/>
            <a:ext cx="4608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 rot="3177000">
            <a:off x="5892840" y="26751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 rot="19968000">
            <a:off x="6110280" y="2201400"/>
            <a:ext cx="4608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 rot="5738400">
            <a:off x="5614920" y="275904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rot="18588000">
            <a:off x="5692680" y="26751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 rot="3850800">
            <a:off x="6048720" y="254700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7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3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294" name=""/>
          <p:cNvSpPr/>
          <p:nvPr/>
        </p:nvSpPr>
        <p:spPr>
          <a:xfrm>
            <a:off x="5603760" y="2317680"/>
            <a:ext cx="19548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 flipV="1">
            <a:off x="3191040" y="2885760"/>
            <a:ext cx="220320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5396040" y="2522520"/>
            <a:ext cx="20772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5973840" y="2060640"/>
            <a:ext cx="287280" cy="1364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 flipV="1">
            <a:off x="5791320" y="2193480"/>
            <a:ext cx="188640" cy="1285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5657760" y="2049480"/>
            <a:ext cx="838440" cy="793800"/>
          </a:xfrm>
          <a:custGeom>
            <a:avLst/>
            <a:gdLst/>
            <a:ahLst/>
            <a:rect l="l" t="t" r="r" b="b"/>
            <a:pathLst>
              <a:path w="624" h="602">
                <a:moveTo>
                  <a:pt x="444" y="23"/>
                </a:moveTo>
                <a:cubicBezTo>
                  <a:pt x="432" y="58"/>
                  <a:pt x="449" y="116"/>
                  <a:pt x="480" y="137"/>
                </a:cubicBezTo>
                <a:cubicBezTo>
                  <a:pt x="484" y="143"/>
                  <a:pt x="489" y="149"/>
                  <a:pt x="492" y="155"/>
                </a:cubicBezTo>
                <a:cubicBezTo>
                  <a:pt x="519" y="209"/>
                  <a:pt x="432" y="207"/>
                  <a:pt x="402" y="227"/>
                </a:cubicBezTo>
                <a:cubicBezTo>
                  <a:pt x="390" y="262"/>
                  <a:pt x="384" y="300"/>
                  <a:pt x="372" y="335"/>
                </a:cubicBezTo>
                <a:cubicBezTo>
                  <a:pt x="370" y="342"/>
                  <a:pt x="366" y="348"/>
                  <a:pt x="360" y="353"/>
                </a:cubicBezTo>
                <a:cubicBezTo>
                  <a:pt x="350" y="361"/>
                  <a:pt x="335" y="364"/>
                  <a:pt x="324" y="371"/>
                </a:cubicBezTo>
                <a:cubicBezTo>
                  <a:pt x="271" y="362"/>
                  <a:pt x="226" y="336"/>
                  <a:pt x="174" y="323"/>
                </a:cubicBezTo>
                <a:cubicBezTo>
                  <a:pt x="142" y="301"/>
                  <a:pt x="156" y="306"/>
                  <a:pt x="96" y="317"/>
                </a:cubicBezTo>
                <a:cubicBezTo>
                  <a:pt x="84" y="319"/>
                  <a:pt x="60" y="329"/>
                  <a:pt x="60" y="329"/>
                </a:cubicBezTo>
                <a:cubicBezTo>
                  <a:pt x="37" y="363"/>
                  <a:pt x="33" y="349"/>
                  <a:pt x="18" y="395"/>
                </a:cubicBezTo>
                <a:cubicBezTo>
                  <a:pt x="14" y="407"/>
                  <a:pt x="10" y="419"/>
                  <a:pt x="6" y="431"/>
                </a:cubicBezTo>
                <a:cubicBezTo>
                  <a:pt x="4" y="437"/>
                  <a:pt x="0" y="449"/>
                  <a:pt x="0" y="449"/>
                </a:cubicBezTo>
                <a:cubicBezTo>
                  <a:pt x="34" y="552"/>
                  <a:pt x="89" y="582"/>
                  <a:pt x="192" y="593"/>
                </a:cubicBezTo>
                <a:cubicBezTo>
                  <a:pt x="221" y="600"/>
                  <a:pt x="211" y="602"/>
                  <a:pt x="240" y="593"/>
                </a:cubicBezTo>
                <a:cubicBezTo>
                  <a:pt x="252" y="589"/>
                  <a:pt x="276" y="581"/>
                  <a:pt x="276" y="581"/>
                </a:cubicBezTo>
                <a:cubicBezTo>
                  <a:pt x="280" y="575"/>
                  <a:pt x="282" y="568"/>
                  <a:pt x="288" y="563"/>
                </a:cubicBezTo>
                <a:cubicBezTo>
                  <a:pt x="293" y="559"/>
                  <a:pt x="302" y="561"/>
                  <a:pt x="306" y="557"/>
                </a:cubicBezTo>
                <a:cubicBezTo>
                  <a:pt x="310" y="553"/>
                  <a:pt x="309" y="545"/>
                  <a:pt x="312" y="539"/>
                </a:cubicBezTo>
                <a:cubicBezTo>
                  <a:pt x="325" y="513"/>
                  <a:pt x="335" y="490"/>
                  <a:pt x="360" y="473"/>
                </a:cubicBezTo>
                <a:cubicBezTo>
                  <a:pt x="362" y="467"/>
                  <a:pt x="362" y="459"/>
                  <a:pt x="366" y="455"/>
                </a:cubicBezTo>
                <a:cubicBezTo>
                  <a:pt x="370" y="451"/>
                  <a:pt x="378" y="452"/>
                  <a:pt x="384" y="449"/>
                </a:cubicBezTo>
                <a:cubicBezTo>
                  <a:pt x="402" y="440"/>
                  <a:pt x="419" y="427"/>
                  <a:pt x="438" y="419"/>
                </a:cubicBezTo>
                <a:cubicBezTo>
                  <a:pt x="502" y="390"/>
                  <a:pt x="451" y="422"/>
                  <a:pt x="492" y="395"/>
                </a:cubicBezTo>
                <a:cubicBezTo>
                  <a:pt x="500" y="383"/>
                  <a:pt x="513" y="373"/>
                  <a:pt x="516" y="359"/>
                </a:cubicBezTo>
                <a:cubicBezTo>
                  <a:pt x="520" y="341"/>
                  <a:pt x="519" y="324"/>
                  <a:pt x="534" y="311"/>
                </a:cubicBezTo>
                <a:cubicBezTo>
                  <a:pt x="545" y="302"/>
                  <a:pt x="570" y="287"/>
                  <a:pt x="570" y="287"/>
                </a:cubicBezTo>
                <a:cubicBezTo>
                  <a:pt x="586" y="239"/>
                  <a:pt x="562" y="295"/>
                  <a:pt x="594" y="263"/>
                </a:cubicBezTo>
                <a:cubicBezTo>
                  <a:pt x="598" y="259"/>
                  <a:pt x="597" y="251"/>
                  <a:pt x="600" y="245"/>
                </a:cubicBezTo>
                <a:cubicBezTo>
                  <a:pt x="607" y="232"/>
                  <a:pt x="624" y="209"/>
                  <a:pt x="624" y="209"/>
                </a:cubicBezTo>
                <a:cubicBezTo>
                  <a:pt x="603" y="147"/>
                  <a:pt x="569" y="108"/>
                  <a:pt x="504" y="95"/>
                </a:cubicBezTo>
                <a:cubicBezTo>
                  <a:pt x="499" y="67"/>
                  <a:pt x="489" y="0"/>
                  <a:pt x="444" y="23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5883120" y="250812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6275520" y="2314440"/>
            <a:ext cx="46080" cy="136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 rot="3177000">
            <a:off x="6006600" y="257508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 rot="19968000">
            <a:off x="6253200" y="207288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 rot="17133000">
            <a:off x="5786280" y="261576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 rot="19675200">
            <a:off x="6378480" y="22032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 rot="3850800">
            <a:off x="6191640" y="241848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8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309" name=""/>
          <p:cNvSpPr/>
          <p:nvPr/>
        </p:nvSpPr>
        <p:spPr>
          <a:xfrm>
            <a:off x="5765760" y="2212920"/>
            <a:ext cx="19548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 flipV="1">
            <a:off x="3352680" y="2781000"/>
            <a:ext cx="220356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5557680" y="2417760"/>
            <a:ext cx="20808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6135840" y="1955880"/>
            <a:ext cx="287280" cy="1364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V="1">
            <a:off x="5952960" y="2088720"/>
            <a:ext cx="189000" cy="1285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5819760" y="1944720"/>
            <a:ext cx="838080" cy="793800"/>
          </a:xfrm>
          <a:custGeom>
            <a:avLst/>
            <a:gdLst/>
            <a:ahLst/>
            <a:rect l="l" t="t" r="r" b="b"/>
            <a:pathLst>
              <a:path w="624" h="602">
                <a:moveTo>
                  <a:pt x="444" y="23"/>
                </a:moveTo>
                <a:cubicBezTo>
                  <a:pt x="432" y="58"/>
                  <a:pt x="449" y="116"/>
                  <a:pt x="480" y="137"/>
                </a:cubicBezTo>
                <a:cubicBezTo>
                  <a:pt x="484" y="143"/>
                  <a:pt x="489" y="149"/>
                  <a:pt x="492" y="155"/>
                </a:cubicBezTo>
                <a:cubicBezTo>
                  <a:pt x="519" y="209"/>
                  <a:pt x="432" y="207"/>
                  <a:pt x="402" y="227"/>
                </a:cubicBezTo>
                <a:cubicBezTo>
                  <a:pt x="390" y="262"/>
                  <a:pt x="384" y="300"/>
                  <a:pt x="372" y="335"/>
                </a:cubicBezTo>
                <a:cubicBezTo>
                  <a:pt x="370" y="342"/>
                  <a:pt x="366" y="348"/>
                  <a:pt x="360" y="353"/>
                </a:cubicBezTo>
                <a:cubicBezTo>
                  <a:pt x="350" y="361"/>
                  <a:pt x="335" y="364"/>
                  <a:pt x="324" y="371"/>
                </a:cubicBezTo>
                <a:cubicBezTo>
                  <a:pt x="271" y="362"/>
                  <a:pt x="226" y="336"/>
                  <a:pt x="174" y="323"/>
                </a:cubicBezTo>
                <a:cubicBezTo>
                  <a:pt x="142" y="301"/>
                  <a:pt x="156" y="306"/>
                  <a:pt x="96" y="317"/>
                </a:cubicBezTo>
                <a:cubicBezTo>
                  <a:pt x="84" y="319"/>
                  <a:pt x="60" y="329"/>
                  <a:pt x="60" y="329"/>
                </a:cubicBezTo>
                <a:cubicBezTo>
                  <a:pt x="37" y="363"/>
                  <a:pt x="33" y="349"/>
                  <a:pt x="18" y="395"/>
                </a:cubicBezTo>
                <a:cubicBezTo>
                  <a:pt x="14" y="407"/>
                  <a:pt x="10" y="419"/>
                  <a:pt x="6" y="431"/>
                </a:cubicBezTo>
                <a:cubicBezTo>
                  <a:pt x="4" y="437"/>
                  <a:pt x="0" y="449"/>
                  <a:pt x="0" y="449"/>
                </a:cubicBezTo>
                <a:cubicBezTo>
                  <a:pt x="34" y="552"/>
                  <a:pt x="89" y="582"/>
                  <a:pt x="192" y="593"/>
                </a:cubicBezTo>
                <a:cubicBezTo>
                  <a:pt x="221" y="600"/>
                  <a:pt x="211" y="602"/>
                  <a:pt x="240" y="593"/>
                </a:cubicBezTo>
                <a:cubicBezTo>
                  <a:pt x="252" y="589"/>
                  <a:pt x="276" y="581"/>
                  <a:pt x="276" y="581"/>
                </a:cubicBezTo>
                <a:cubicBezTo>
                  <a:pt x="280" y="575"/>
                  <a:pt x="282" y="568"/>
                  <a:pt x="288" y="563"/>
                </a:cubicBezTo>
                <a:cubicBezTo>
                  <a:pt x="293" y="559"/>
                  <a:pt x="302" y="561"/>
                  <a:pt x="306" y="557"/>
                </a:cubicBezTo>
                <a:cubicBezTo>
                  <a:pt x="310" y="553"/>
                  <a:pt x="309" y="545"/>
                  <a:pt x="312" y="539"/>
                </a:cubicBezTo>
                <a:cubicBezTo>
                  <a:pt x="325" y="513"/>
                  <a:pt x="335" y="490"/>
                  <a:pt x="360" y="473"/>
                </a:cubicBezTo>
                <a:cubicBezTo>
                  <a:pt x="362" y="467"/>
                  <a:pt x="362" y="459"/>
                  <a:pt x="366" y="455"/>
                </a:cubicBezTo>
                <a:cubicBezTo>
                  <a:pt x="370" y="451"/>
                  <a:pt x="378" y="452"/>
                  <a:pt x="384" y="449"/>
                </a:cubicBezTo>
                <a:cubicBezTo>
                  <a:pt x="402" y="440"/>
                  <a:pt x="419" y="427"/>
                  <a:pt x="438" y="419"/>
                </a:cubicBezTo>
                <a:cubicBezTo>
                  <a:pt x="502" y="390"/>
                  <a:pt x="451" y="422"/>
                  <a:pt x="492" y="395"/>
                </a:cubicBezTo>
                <a:cubicBezTo>
                  <a:pt x="500" y="383"/>
                  <a:pt x="513" y="373"/>
                  <a:pt x="516" y="359"/>
                </a:cubicBezTo>
                <a:cubicBezTo>
                  <a:pt x="520" y="341"/>
                  <a:pt x="519" y="324"/>
                  <a:pt x="534" y="311"/>
                </a:cubicBezTo>
                <a:cubicBezTo>
                  <a:pt x="545" y="302"/>
                  <a:pt x="570" y="287"/>
                  <a:pt x="570" y="287"/>
                </a:cubicBezTo>
                <a:cubicBezTo>
                  <a:pt x="586" y="239"/>
                  <a:pt x="562" y="295"/>
                  <a:pt x="594" y="263"/>
                </a:cubicBezTo>
                <a:cubicBezTo>
                  <a:pt x="598" y="259"/>
                  <a:pt x="597" y="251"/>
                  <a:pt x="600" y="245"/>
                </a:cubicBezTo>
                <a:cubicBezTo>
                  <a:pt x="607" y="232"/>
                  <a:pt x="624" y="209"/>
                  <a:pt x="624" y="209"/>
                </a:cubicBezTo>
                <a:cubicBezTo>
                  <a:pt x="603" y="147"/>
                  <a:pt x="569" y="108"/>
                  <a:pt x="504" y="95"/>
                </a:cubicBezTo>
                <a:cubicBezTo>
                  <a:pt x="499" y="67"/>
                  <a:pt x="489" y="0"/>
                  <a:pt x="444" y="23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6054840" y="242244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6446880" y="2214720"/>
            <a:ext cx="4608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 rot="3177000">
            <a:off x="6192720" y="24606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rot="19968000">
            <a:off x="6424560" y="1972800"/>
            <a:ext cx="4608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rot="7176600">
            <a:off x="5986080" y="253008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rot="19675200">
            <a:off x="6550200" y="2074680"/>
            <a:ext cx="4572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rot="3850800">
            <a:off x="6363000" y="230400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29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3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3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324" name=""/>
          <p:cNvSpPr/>
          <p:nvPr/>
        </p:nvSpPr>
        <p:spPr>
          <a:xfrm>
            <a:off x="5908680" y="2117880"/>
            <a:ext cx="195120" cy="20448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 flipV="1">
            <a:off x="3495600" y="2685600"/>
            <a:ext cx="2203560" cy="1484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5700600" y="2322360"/>
            <a:ext cx="20808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6278400" y="1860480"/>
            <a:ext cx="287640" cy="1364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flipV="1">
            <a:off x="6095880" y="1993680"/>
            <a:ext cx="189000" cy="1285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5952960" y="1849320"/>
            <a:ext cx="838440" cy="793800"/>
          </a:xfrm>
          <a:custGeom>
            <a:avLst/>
            <a:gdLst/>
            <a:ahLst/>
            <a:rect l="l" t="t" r="r" b="b"/>
            <a:pathLst>
              <a:path w="624" h="602">
                <a:moveTo>
                  <a:pt x="444" y="23"/>
                </a:moveTo>
                <a:cubicBezTo>
                  <a:pt x="432" y="58"/>
                  <a:pt x="449" y="116"/>
                  <a:pt x="480" y="137"/>
                </a:cubicBezTo>
                <a:cubicBezTo>
                  <a:pt x="484" y="143"/>
                  <a:pt x="489" y="149"/>
                  <a:pt x="492" y="155"/>
                </a:cubicBezTo>
                <a:cubicBezTo>
                  <a:pt x="519" y="209"/>
                  <a:pt x="432" y="207"/>
                  <a:pt x="402" y="227"/>
                </a:cubicBezTo>
                <a:cubicBezTo>
                  <a:pt x="390" y="262"/>
                  <a:pt x="384" y="300"/>
                  <a:pt x="372" y="335"/>
                </a:cubicBezTo>
                <a:cubicBezTo>
                  <a:pt x="370" y="342"/>
                  <a:pt x="366" y="348"/>
                  <a:pt x="360" y="353"/>
                </a:cubicBezTo>
                <a:cubicBezTo>
                  <a:pt x="350" y="361"/>
                  <a:pt x="335" y="364"/>
                  <a:pt x="324" y="371"/>
                </a:cubicBezTo>
                <a:cubicBezTo>
                  <a:pt x="271" y="362"/>
                  <a:pt x="226" y="336"/>
                  <a:pt x="174" y="323"/>
                </a:cubicBezTo>
                <a:cubicBezTo>
                  <a:pt x="142" y="301"/>
                  <a:pt x="156" y="306"/>
                  <a:pt x="96" y="317"/>
                </a:cubicBezTo>
                <a:cubicBezTo>
                  <a:pt x="84" y="319"/>
                  <a:pt x="60" y="329"/>
                  <a:pt x="60" y="329"/>
                </a:cubicBezTo>
                <a:cubicBezTo>
                  <a:pt x="37" y="363"/>
                  <a:pt x="33" y="349"/>
                  <a:pt x="18" y="395"/>
                </a:cubicBezTo>
                <a:cubicBezTo>
                  <a:pt x="14" y="407"/>
                  <a:pt x="10" y="419"/>
                  <a:pt x="6" y="431"/>
                </a:cubicBezTo>
                <a:cubicBezTo>
                  <a:pt x="4" y="437"/>
                  <a:pt x="0" y="449"/>
                  <a:pt x="0" y="449"/>
                </a:cubicBezTo>
                <a:cubicBezTo>
                  <a:pt x="34" y="552"/>
                  <a:pt x="89" y="582"/>
                  <a:pt x="192" y="593"/>
                </a:cubicBezTo>
                <a:cubicBezTo>
                  <a:pt x="221" y="600"/>
                  <a:pt x="211" y="602"/>
                  <a:pt x="240" y="593"/>
                </a:cubicBezTo>
                <a:cubicBezTo>
                  <a:pt x="252" y="589"/>
                  <a:pt x="276" y="581"/>
                  <a:pt x="276" y="581"/>
                </a:cubicBezTo>
                <a:cubicBezTo>
                  <a:pt x="280" y="575"/>
                  <a:pt x="282" y="568"/>
                  <a:pt x="288" y="563"/>
                </a:cubicBezTo>
                <a:cubicBezTo>
                  <a:pt x="293" y="559"/>
                  <a:pt x="302" y="561"/>
                  <a:pt x="306" y="557"/>
                </a:cubicBezTo>
                <a:cubicBezTo>
                  <a:pt x="310" y="553"/>
                  <a:pt x="309" y="545"/>
                  <a:pt x="312" y="539"/>
                </a:cubicBezTo>
                <a:cubicBezTo>
                  <a:pt x="325" y="513"/>
                  <a:pt x="335" y="490"/>
                  <a:pt x="360" y="473"/>
                </a:cubicBezTo>
                <a:cubicBezTo>
                  <a:pt x="362" y="467"/>
                  <a:pt x="362" y="459"/>
                  <a:pt x="366" y="455"/>
                </a:cubicBezTo>
                <a:cubicBezTo>
                  <a:pt x="370" y="451"/>
                  <a:pt x="378" y="452"/>
                  <a:pt x="384" y="449"/>
                </a:cubicBezTo>
                <a:cubicBezTo>
                  <a:pt x="402" y="440"/>
                  <a:pt x="419" y="427"/>
                  <a:pt x="438" y="419"/>
                </a:cubicBezTo>
                <a:cubicBezTo>
                  <a:pt x="502" y="390"/>
                  <a:pt x="451" y="422"/>
                  <a:pt x="492" y="395"/>
                </a:cubicBezTo>
                <a:cubicBezTo>
                  <a:pt x="500" y="383"/>
                  <a:pt x="513" y="373"/>
                  <a:pt x="516" y="359"/>
                </a:cubicBezTo>
                <a:cubicBezTo>
                  <a:pt x="520" y="341"/>
                  <a:pt x="519" y="324"/>
                  <a:pt x="534" y="311"/>
                </a:cubicBezTo>
                <a:cubicBezTo>
                  <a:pt x="545" y="302"/>
                  <a:pt x="570" y="287"/>
                  <a:pt x="570" y="287"/>
                </a:cubicBezTo>
                <a:cubicBezTo>
                  <a:pt x="586" y="239"/>
                  <a:pt x="562" y="295"/>
                  <a:pt x="594" y="263"/>
                </a:cubicBezTo>
                <a:cubicBezTo>
                  <a:pt x="598" y="259"/>
                  <a:pt x="597" y="251"/>
                  <a:pt x="600" y="245"/>
                </a:cubicBezTo>
                <a:cubicBezTo>
                  <a:pt x="607" y="232"/>
                  <a:pt x="624" y="209"/>
                  <a:pt x="624" y="209"/>
                </a:cubicBezTo>
                <a:cubicBezTo>
                  <a:pt x="603" y="147"/>
                  <a:pt x="569" y="108"/>
                  <a:pt x="504" y="95"/>
                </a:cubicBezTo>
                <a:cubicBezTo>
                  <a:pt x="499" y="67"/>
                  <a:pt x="489" y="0"/>
                  <a:pt x="444" y="23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6197760" y="2322360"/>
            <a:ext cx="4572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6618240" y="2100240"/>
            <a:ext cx="46080" cy="136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 rot="3177000">
            <a:off x="6335640" y="2360160"/>
            <a:ext cx="4572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 rot="19968000">
            <a:off x="6567480" y="1872720"/>
            <a:ext cx="46080" cy="109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 rot="6830400">
            <a:off x="6100200" y="241596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 rot="19675200">
            <a:off x="6692760" y="197460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 rot="3850800">
            <a:off x="6505920" y="218988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30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8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339" name=""/>
          <p:cNvSpPr/>
          <p:nvPr/>
        </p:nvSpPr>
        <p:spPr>
          <a:xfrm>
            <a:off x="6070680" y="2003400"/>
            <a:ext cx="195120" cy="204840"/>
          </a:xfrm>
          <a:custGeom>
            <a:avLst/>
            <a:gdLst/>
            <a:ahLst/>
            <a:rect l="l" t="t" r="r" b="b"/>
            <a:pathLst>
              <a:path w="342" h="360">
                <a:moveTo>
                  <a:pt x="0" y="360"/>
                </a:moveTo>
                <a:cubicBezTo>
                  <a:pt x="7" y="335"/>
                  <a:pt x="14" y="310"/>
                  <a:pt x="24" y="288"/>
                </a:cubicBezTo>
                <a:cubicBezTo>
                  <a:pt x="34" y="266"/>
                  <a:pt x="44" y="249"/>
                  <a:pt x="60" y="228"/>
                </a:cubicBezTo>
                <a:cubicBezTo>
                  <a:pt x="76" y="207"/>
                  <a:pt x="96" y="185"/>
                  <a:pt x="120" y="162"/>
                </a:cubicBezTo>
                <a:cubicBezTo>
                  <a:pt x="144" y="139"/>
                  <a:pt x="167" y="117"/>
                  <a:pt x="204" y="90"/>
                </a:cubicBezTo>
                <a:cubicBezTo>
                  <a:pt x="241" y="63"/>
                  <a:pt x="291" y="31"/>
                  <a:pt x="342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 flipV="1">
            <a:off x="4257720" y="2571840"/>
            <a:ext cx="1603440" cy="107928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5862600" y="2208240"/>
            <a:ext cx="208080" cy="363600"/>
          </a:xfrm>
          <a:custGeom>
            <a:avLst/>
            <a:gdLst/>
            <a:ahLst/>
            <a:rect l="l" t="t" r="r" b="b"/>
            <a:pathLst>
              <a:path w="204" h="360">
                <a:moveTo>
                  <a:pt x="0" y="360"/>
                </a:moveTo>
                <a:cubicBezTo>
                  <a:pt x="34" y="333"/>
                  <a:pt x="68" y="306"/>
                  <a:pt x="90" y="282"/>
                </a:cubicBezTo>
                <a:cubicBezTo>
                  <a:pt x="112" y="258"/>
                  <a:pt x="120" y="240"/>
                  <a:pt x="132" y="216"/>
                </a:cubicBezTo>
                <a:cubicBezTo>
                  <a:pt x="144" y="192"/>
                  <a:pt x="150" y="174"/>
                  <a:pt x="162" y="138"/>
                </a:cubicBezTo>
                <a:cubicBezTo>
                  <a:pt x="174" y="102"/>
                  <a:pt x="189" y="51"/>
                  <a:pt x="204" y="0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6440400" y="1746360"/>
            <a:ext cx="287280" cy="136440"/>
          </a:xfrm>
          <a:custGeom>
            <a:avLst/>
            <a:gdLst/>
            <a:ahLst/>
            <a:rect l="l" t="t" r="r" b="b"/>
            <a:pathLst>
              <a:path w="504" h="238">
                <a:moveTo>
                  <a:pt x="0" y="238"/>
                </a:moveTo>
                <a:cubicBezTo>
                  <a:pt x="63" y="195"/>
                  <a:pt x="127" y="153"/>
                  <a:pt x="180" y="118"/>
                </a:cubicBezTo>
                <a:cubicBezTo>
                  <a:pt x="233" y="83"/>
                  <a:pt x="285" y="47"/>
                  <a:pt x="318" y="28"/>
                </a:cubicBezTo>
                <a:cubicBezTo>
                  <a:pt x="351" y="9"/>
                  <a:pt x="361" y="8"/>
                  <a:pt x="378" y="4"/>
                </a:cubicBezTo>
                <a:cubicBezTo>
                  <a:pt x="395" y="0"/>
                  <a:pt x="404" y="1"/>
                  <a:pt x="420" y="4"/>
                </a:cubicBezTo>
                <a:cubicBezTo>
                  <a:pt x="436" y="7"/>
                  <a:pt x="460" y="15"/>
                  <a:pt x="474" y="22"/>
                </a:cubicBezTo>
                <a:cubicBezTo>
                  <a:pt x="488" y="29"/>
                  <a:pt x="496" y="37"/>
                  <a:pt x="504" y="46"/>
                </a:cubicBezTo>
              </a:path>
            </a:pathLst>
          </a:custGeom>
          <a:noFill/>
          <a:ln w="38160">
            <a:solidFill>
              <a:srgbClr val="d8203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 flipV="1">
            <a:off x="6257880" y="1879200"/>
            <a:ext cx="189000" cy="1285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6669000" y="1743120"/>
            <a:ext cx="198360" cy="231840"/>
          </a:xfrm>
          <a:custGeom>
            <a:avLst/>
            <a:gdLst/>
            <a:ahLst/>
            <a:rect l="l" t="t" r="r" b="b"/>
            <a:pathLst>
              <a:path w="125" h="146">
                <a:moveTo>
                  <a:pt x="17" y="18"/>
                </a:moveTo>
                <a:cubicBezTo>
                  <a:pt x="7" y="48"/>
                  <a:pt x="0" y="103"/>
                  <a:pt x="23" y="126"/>
                </a:cubicBezTo>
                <a:cubicBezTo>
                  <a:pt x="32" y="135"/>
                  <a:pt x="48" y="137"/>
                  <a:pt x="59" y="144"/>
                </a:cubicBezTo>
                <a:cubicBezTo>
                  <a:pt x="92" y="139"/>
                  <a:pt x="114" y="146"/>
                  <a:pt x="125" y="114"/>
                </a:cubicBezTo>
                <a:cubicBezTo>
                  <a:pt x="118" y="86"/>
                  <a:pt x="119" y="76"/>
                  <a:pt x="95" y="60"/>
                </a:cubicBezTo>
                <a:cubicBezTo>
                  <a:pt x="91" y="54"/>
                  <a:pt x="88" y="47"/>
                  <a:pt x="83" y="42"/>
                </a:cubicBezTo>
                <a:cubicBezTo>
                  <a:pt x="78" y="37"/>
                  <a:pt x="70" y="36"/>
                  <a:pt x="65" y="30"/>
                </a:cubicBezTo>
                <a:cubicBezTo>
                  <a:pt x="61" y="25"/>
                  <a:pt x="64" y="16"/>
                  <a:pt x="59" y="12"/>
                </a:cubicBezTo>
                <a:cubicBezTo>
                  <a:pt x="49" y="5"/>
                  <a:pt x="23" y="0"/>
                  <a:pt x="23" y="0"/>
                </a:cubicBezTo>
                <a:cubicBezTo>
                  <a:pt x="10" y="20"/>
                  <a:pt x="4" y="18"/>
                  <a:pt x="17" y="18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 rot="21192000">
            <a:off x="6089760" y="2126880"/>
            <a:ext cx="812520" cy="457200"/>
          </a:xfrm>
          <a:custGeom>
            <a:avLst/>
            <a:gdLst/>
            <a:ahLst/>
            <a:rect l="l" t="t" r="r" b="b"/>
            <a:pathLst>
              <a:path w="534" h="295">
                <a:moveTo>
                  <a:pt x="474" y="36"/>
                </a:moveTo>
                <a:cubicBezTo>
                  <a:pt x="457" y="34"/>
                  <a:pt x="413" y="36"/>
                  <a:pt x="390" y="24"/>
                </a:cubicBezTo>
                <a:cubicBezTo>
                  <a:pt x="372" y="15"/>
                  <a:pt x="336" y="0"/>
                  <a:pt x="336" y="0"/>
                </a:cubicBezTo>
                <a:cubicBezTo>
                  <a:pt x="230" y="15"/>
                  <a:pt x="219" y="19"/>
                  <a:pt x="78" y="24"/>
                </a:cubicBezTo>
                <a:cubicBezTo>
                  <a:pt x="33" y="39"/>
                  <a:pt x="22" y="115"/>
                  <a:pt x="12" y="156"/>
                </a:cubicBezTo>
                <a:cubicBezTo>
                  <a:pt x="9" y="168"/>
                  <a:pt x="0" y="192"/>
                  <a:pt x="0" y="192"/>
                </a:cubicBezTo>
                <a:cubicBezTo>
                  <a:pt x="14" y="235"/>
                  <a:pt x="1" y="221"/>
                  <a:pt x="30" y="240"/>
                </a:cubicBezTo>
                <a:cubicBezTo>
                  <a:pt x="48" y="295"/>
                  <a:pt x="142" y="260"/>
                  <a:pt x="180" y="258"/>
                </a:cubicBezTo>
                <a:cubicBezTo>
                  <a:pt x="212" y="247"/>
                  <a:pt x="244" y="239"/>
                  <a:pt x="276" y="228"/>
                </a:cubicBezTo>
                <a:cubicBezTo>
                  <a:pt x="290" y="223"/>
                  <a:pt x="298" y="209"/>
                  <a:pt x="312" y="204"/>
                </a:cubicBezTo>
                <a:cubicBezTo>
                  <a:pt x="338" y="195"/>
                  <a:pt x="359" y="179"/>
                  <a:pt x="384" y="168"/>
                </a:cubicBezTo>
                <a:cubicBezTo>
                  <a:pt x="420" y="152"/>
                  <a:pt x="458" y="142"/>
                  <a:pt x="492" y="120"/>
                </a:cubicBezTo>
                <a:cubicBezTo>
                  <a:pt x="500" y="95"/>
                  <a:pt x="513" y="98"/>
                  <a:pt x="534" y="84"/>
                </a:cubicBezTo>
                <a:cubicBezTo>
                  <a:pt x="525" y="56"/>
                  <a:pt x="501" y="55"/>
                  <a:pt x="474" y="48"/>
                </a:cubicBezTo>
                <a:cubicBezTo>
                  <a:pt x="466" y="46"/>
                  <a:pt x="450" y="50"/>
                  <a:pt x="450" y="42"/>
                </a:cubicBezTo>
                <a:cubicBezTo>
                  <a:pt x="450" y="34"/>
                  <a:pt x="466" y="38"/>
                  <a:pt x="474" y="36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808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6626160" y="213660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6289560" y="2314440"/>
            <a:ext cx="46080" cy="136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 rot="3177000">
            <a:off x="6292800" y="238932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 rot="19968000">
            <a:off x="6267240" y="2187720"/>
            <a:ext cx="4572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 rot="1428600">
            <a:off x="6172200" y="231588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 rot="18227400">
            <a:off x="6478200" y="214596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 rot="3850800">
            <a:off x="6477120" y="227556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 rot="19968000">
            <a:off x="6738840" y="180144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31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5" name="" descr=""/>
          <p:cNvPicPr/>
          <p:nvPr/>
        </p:nvPicPr>
        <p:blipFill>
          <a:blip r:embed="rId1"/>
          <a:srcRect l="19816" t="17538" r="1868" b="5757"/>
          <a:stretch/>
        </p:blipFill>
        <p:spPr>
          <a:xfrm>
            <a:off x="1392120" y="1184400"/>
            <a:ext cx="6359760" cy="4489200"/>
          </a:xfrm>
          <a:prstGeom prst="rect">
            <a:avLst/>
          </a:prstGeom>
          <a:ln w="0">
            <a:noFill/>
          </a:ln>
        </p:spPr>
      </p:pic>
      <p:sp>
        <p:nvSpPr>
          <p:cNvPr id="356" name=""/>
          <p:cNvSpPr/>
          <p:nvPr/>
        </p:nvSpPr>
        <p:spPr>
          <a:xfrm rot="21192000">
            <a:off x="6079680" y="1980720"/>
            <a:ext cx="933480" cy="595440"/>
          </a:xfrm>
          <a:custGeom>
            <a:avLst/>
            <a:gdLst/>
            <a:ahLst/>
            <a:rect l="l" t="t" r="r" b="b"/>
            <a:pathLst>
              <a:path w="534" h="295">
                <a:moveTo>
                  <a:pt x="474" y="36"/>
                </a:moveTo>
                <a:cubicBezTo>
                  <a:pt x="457" y="34"/>
                  <a:pt x="413" y="36"/>
                  <a:pt x="390" y="24"/>
                </a:cubicBezTo>
                <a:cubicBezTo>
                  <a:pt x="372" y="15"/>
                  <a:pt x="336" y="0"/>
                  <a:pt x="336" y="0"/>
                </a:cubicBezTo>
                <a:cubicBezTo>
                  <a:pt x="230" y="15"/>
                  <a:pt x="219" y="19"/>
                  <a:pt x="78" y="24"/>
                </a:cubicBezTo>
                <a:cubicBezTo>
                  <a:pt x="33" y="39"/>
                  <a:pt x="22" y="115"/>
                  <a:pt x="12" y="156"/>
                </a:cubicBezTo>
                <a:cubicBezTo>
                  <a:pt x="9" y="168"/>
                  <a:pt x="0" y="192"/>
                  <a:pt x="0" y="192"/>
                </a:cubicBezTo>
                <a:cubicBezTo>
                  <a:pt x="14" y="235"/>
                  <a:pt x="1" y="221"/>
                  <a:pt x="30" y="240"/>
                </a:cubicBezTo>
                <a:cubicBezTo>
                  <a:pt x="48" y="295"/>
                  <a:pt x="142" y="260"/>
                  <a:pt x="180" y="258"/>
                </a:cubicBezTo>
                <a:cubicBezTo>
                  <a:pt x="212" y="247"/>
                  <a:pt x="244" y="239"/>
                  <a:pt x="276" y="228"/>
                </a:cubicBezTo>
                <a:cubicBezTo>
                  <a:pt x="290" y="223"/>
                  <a:pt x="298" y="209"/>
                  <a:pt x="312" y="204"/>
                </a:cubicBezTo>
                <a:cubicBezTo>
                  <a:pt x="338" y="195"/>
                  <a:pt x="359" y="179"/>
                  <a:pt x="384" y="168"/>
                </a:cubicBezTo>
                <a:cubicBezTo>
                  <a:pt x="420" y="152"/>
                  <a:pt x="458" y="142"/>
                  <a:pt x="492" y="120"/>
                </a:cubicBezTo>
                <a:cubicBezTo>
                  <a:pt x="500" y="95"/>
                  <a:pt x="513" y="98"/>
                  <a:pt x="534" y="84"/>
                </a:cubicBezTo>
                <a:cubicBezTo>
                  <a:pt x="525" y="56"/>
                  <a:pt x="501" y="55"/>
                  <a:pt x="474" y="48"/>
                </a:cubicBezTo>
                <a:cubicBezTo>
                  <a:pt x="466" y="46"/>
                  <a:pt x="450" y="50"/>
                  <a:pt x="450" y="42"/>
                </a:cubicBezTo>
                <a:cubicBezTo>
                  <a:pt x="450" y="34"/>
                  <a:pt x="466" y="38"/>
                  <a:pt x="474" y="36"/>
                </a:cubicBezTo>
                <a:close/>
              </a:path>
            </a:pathLst>
          </a:custGeom>
          <a:gradFill rotWithShape="0">
            <a:gsLst>
              <a:gs pos="0">
                <a:srgbClr val="d82036"/>
              </a:gs>
              <a:gs pos="100000">
                <a:srgbClr val="630e18"/>
              </a:gs>
            </a:gsLst>
            <a:lin ang="5808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6640560" y="209376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6289560" y="2314440"/>
            <a:ext cx="46080" cy="1368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 rot="3177000">
            <a:off x="6292800" y="238932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 rot="19968000">
            <a:off x="6267240" y="2187720"/>
            <a:ext cx="4572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 rot="1428600">
            <a:off x="6172200" y="231588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 rot="18227400">
            <a:off x="6406920" y="211752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 rot="3850800">
            <a:off x="6477120" y="2275560"/>
            <a:ext cx="46080" cy="22860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 rot="19968000">
            <a:off x="6510240" y="2087280"/>
            <a:ext cx="46080" cy="1094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3170520" y="647640"/>
            <a:ext cx="289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32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4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 flipV="1">
            <a:off x="3200400" y="4091040"/>
            <a:ext cx="371520" cy="2491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5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 flipV="1">
            <a:off x="3067200" y="4098600"/>
            <a:ext cx="492120" cy="33012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6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 flipV="1">
            <a:off x="2901960" y="4043520"/>
            <a:ext cx="739800" cy="49680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3480000">
            <a:off x="3049560" y="4331880"/>
            <a:ext cx="46080" cy="195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7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 flipV="1">
            <a:off x="2755800" y="4005000"/>
            <a:ext cx="943200" cy="63180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3360000">
            <a:off x="3040560" y="413748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3480000">
            <a:off x="3492000" y="403200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8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rcRect l="19816" t="17444" r="1868" b="5726"/>
          <a:stretch/>
        </p:blipFill>
        <p:spPr>
          <a:xfrm>
            <a:off x="1409760" y="1181160"/>
            <a:ext cx="6324480" cy="449568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 flipV="1">
            <a:off x="2603520" y="3971880"/>
            <a:ext cx="1146240" cy="76680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2798640" y="3962160"/>
            <a:ext cx="943200" cy="631800"/>
          </a:xfrm>
          <a:prstGeom prst="line">
            <a:avLst/>
          </a:prstGeom>
          <a:ln w="38160">
            <a:solidFill>
              <a:srgbClr val="d8203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3360000">
            <a:off x="3083400" y="4094640"/>
            <a:ext cx="42840" cy="600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3480000">
            <a:off x="3534840" y="3989160"/>
            <a:ext cx="46080" cy="195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170160" y="647640"/>
            <a:ext cx="27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Arial"/>
              </a:rPr>
              <a:t>Animation frame 9 of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04T02:28:51Z</dcterms:created>
  <dc:creator>Admininstrator</dc:creator>
  <dc:description/>
  <dc:language>en-US</dc:language>
  <cp:lastModifiedBy>home</cp:lastModifiedBy>
  <dcterms:modified xsi:type="dcterms:W3CDTF">2006-09-07T06:21:51Z</dcterms:modified>
  <cp:revision>70</cp:revision>
  <dc:subject/>
  <dc:title>Slide 1</dc:title>
</cp:coreProperties>
</file>